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59" r:id="rId4"/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2E2BF6-23CD-4CC0-BA47-8F2E419E0B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86D503-3AEF-44D8-BEEA-2B20B9133C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1BC1F5-198F-4265-868B-2A6912A1D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9F56C5-91B0-4B26-96E2-EEEC27A3B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764DA1-D03B-44D6-A244-61B4ED5AD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2748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177B8-2EE1-4174-9445-C2B51BF516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9B768B-68CF-4201-B920-06DDA7409D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87E827-211F-49C2-82CB-764FAFC0D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D2DEB0-068A-4A80-8C68-A31AB987E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011A8-54D2-4971-B6D0-6ABF209E2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90902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42B3E7-228B-4FB3-8C7A-DF0DCB53C5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0E0310-427E-4936-9A29-F33B8388BB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23ACBC-360F-4EB6-B292-6E31CCC3B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532E85-6C90-4534-93A7-3676D5D20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7BB952-C8C1-46EE-8296-A5BF201539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1890445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Shape 5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Shape 57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hape 5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743343289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3BA6A5-ABD4-406C-AE38-D95389C7D1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75DD42-C921-4054-815A-2AAC9547F8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1A1539-9364-442A-8C68-B3C4496E5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66D45-435A-4790-AFD3-0F1C6B7A7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D49466-C7E3-4024-96C4-C1273F209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15885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A8C35-2FE9-4434-A6CA-8831E7C90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EFD4C2-8567-4328-ACC1-FBF22A17AE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B688C4-E560-4B9E-91E9-1E6038212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A4FC52-F58E-4C54-BF6D-4659712AB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D378CA-E92D-4F09-B041-9C5A2CE1B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94666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2F3244-3CA6-4DC7-B8A8-4AAD8518B4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804B9E-D74B-4DDE-A9FA-EBCA2A1220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A9A222-1A03-45B4-A406-0109C46C43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77A5B0-EB58-44B9-8E7D-0BECD3B57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5D6328-BA82-41FE-818B-98360A910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9A6351-73AD-437B-B801-C31C7E8D9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03515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650949-7798-48B1-835A-4C9CDBB033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823D8D-A4D9-461A-9BE2-EEEAE40ED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E37939-2543-4A85-8F83-345B6A74DF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C16D71F-9CFC-4A0A-AD9E-358908FAB3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3C8003-2F6A-4F81-8AC4-EFB7067EC5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CB69AD-A861-43DA-8016-E95710DAE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1DB37F0-C47C-4B35-B250-E93CE9434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B065072-6D46-4A03-BD65-7F25719BC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96302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709702-28E3-4231-B0F2-38C3845ED4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DB0BEC-4DFA-4A1A-A886-6F85D78C9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1A5D59-D77A-4541-B49F-39EAA3A75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49AA02-B3C3-4A08-9AAD-0DCC41AF2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0632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2E9729A-ED67-4B8E-9073-AFA1B2D15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678351-69A8-4F73-B9D6-B4C0F5AFC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976D9B-D6C9-4946-968E-4E10B8323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8254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E6117-7C90-414E-B80D-009244FB8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CCB08B-7F64-4945-94A1-6B5E92BEBE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832FCF-1FEE-4A4D-8184-DB1D7B3A09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2CECB7-A364-4A6F-8D07-ABC8C0828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7BF7AF-DB41-476C-80A8-9C9BADD52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609463-8990-4FE9-B494-0C6876DDE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9003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9ED272-F5AD-4606-97EB-3E51BB3BF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7092A6-8AAD-4C08-97BB-22A1289011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5E81BC-9586-4FAD-A147-3CCD064F0A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64AD20-393A-4A35-9B98-D81C9B37E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D1BDF8-FF90-4CA0-9CE3-84B4BFDCB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FCF77F-0A29-4486-81E2-73BFE8F32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62102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706A8B-B60F-4643-A029-1A159B071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B6EFA1-3920-467F-86A4-9B7C59C880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E56976-6D61-42C0-9644-430C43D73E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D8914-B7AC-479B-9BE7-72FC152D7CE6}" type="datetimeFigureOut">
              <a:rPr lang="en-CA" smtClean="0"/>
              <a:t>2018-12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898EF9-B649-428F-8964-8F2152D500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3BB598-FB86-414C-86B9-E587925F54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124BF-4F13-4A83-B755-0B31220148A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8597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1.emf"/><Relationship Id="rId4" Type="http://schemas.openxmlformats.org/officeDocument/2006/relationships/image" Target="../media/image3.png"/><Relationship Id="rId9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image" Target="../media/image22.emf"/><Relationship Id="rId3" Type="http://schemas.openxmlformats.org/officeDocument/2006/relationships/image" Target="../media/image12.tif"/><Relationship Id="rId7" Type="http://schemas.openxmlformats.org/officeDocument/2006/relationships/image" Target="../media/image16.emf"/><Relationship Id="rId12" Type="http://schemas.openxmlformats.org/officeDocument/2006/relationships/image" Target="../media/image21.em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11" Type="http://schemas.openxmlformats.org/officeDocument/2006/relationships/image" Target="../media/image20.emf"/><Relationship Id="rId5" Type="http://schemas.openxmlformats.org/officeDocument/2006/relationships/image" Target="../media/image14.tif"/><Relationship Id="rId10" Type="http://schemas.openxmlformats.org/officeDocument/2006/relationships/image" Target="../media/image19.emf"/><Relationship Id="rId4" Type="http://schemas.openxmlformats.org/officeDocument/2006/relationships/image" Target="../media/image13.tif"/><Relationship Id="rId9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0" name="Group 290"/>
          <p:cNvGrpSpPr/>
          <p:nvPr/>
        </p:nvGrpSpPr>
        <p:grpSpPr>
          <a:xfrm>
            <a:off x="750137" y="912989"/>
            <a:ext cx="5190467" cy="3406033"/>
            <a:chOff x="-620688" y="-292117"/>
            <a:chExt cx="6901112" cy="4164761"/>
          </a:xfrm>
        </p:grpSpPr>
        <p:sp>
          <p:nvSpPr>
            <p:cNvPr id="256" name="Shape 256"/>
            <p:cNvSpPr/>
            <p:nvPr/>
          </p:nvSpPr>
          <p:spPr>
            <a:xfrm>
              <a:off x="5762091" y="776453"/>
              <a:ext cx="502275" cy="28240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/>
            <a:p>
              <a:pPr defTabSz="642915">
                <a:defRPr sz="1800"/>
              </a:pPr>
              <a:r>
                <a:rPr sz="1200" dirty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  <a:sym typeface="Times New Roman"/>
                </a:rPr>
                <a:t>IgG</a:t>
              </a:r>
              <a:r>
                <a:rPr sz="1200" baseline="30000" dirty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  <a:sym typeface="Times New Roman"/>
                </a:rPr>
                <a:t>-</a:t>
              </a:r>
            </a:p>
          </p:txBody>
        </p:sp>
        <p:sp>
          <p:nvSpPr>
            <p:cNvPr id="257" name="Shape 257"/>
            <p:cNvSpPr/>
            <p:nvPr/>
          </p:nvSpPr>
          <p:spPr>
            <a:xfrm>
              <a:off x="5746033" y="2220147"/>
              <a:ext cx="534391" cy="28240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/>
            <a:p>
              <a:pPr defTabSz="642915">
                <a:defRPr sz="1800"/>
              </a:pPr>
              <a:r>
                <a:rPr sz="1200" dirty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  <a:sym typeface="Times New Roman"/>
                </a:rPr>
                <a:t>IgG</a:t>
              </a:r>
              <a:r>
                <a:rPr sz="1200" baseline="30000" dirty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  <a:sym typeface="Times New Roman"/>
                </a:rPr>
                <a:t>+</a:t>
              </a:r>
            </a:p>
          </p:txBody>
        </p:sp>
        <p:sp>
          <p:nvSpPr>
            <p:cNvPr id="258" name="Shape 258"/>
            <p:cNvSpPr/>
            <p:nvPr/>
          </p:nvSpPr>
          <p:spPr>
            <a:xfrm>
              <a:off x="-620688" y="1602203"/>
              <a:ext cx="1127350" cy="45159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914400">
                <a:spcBef>
                  <a:spcPts val="700"/>
                </a:spcBef>
                <a:defRPr sz="12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lang="en-CA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259" name="Shape 259"/>
            <p:cNvSpPr/>
            <p:nvPr/>
          </p:nvSpPr>
          <p:spPr>
            <a:xfrm>
              <a:off x="1362971" y="3465500"/>
              <a:ext cx="1043255" cy="3765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914400">
                <a:spcBef>
                  <a:spcPts val="700"/>
                </a:spcBef>
                <a:defRPr sz="12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dirty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  <a:r>
                <a:rPr lang="en-CA" dirty="0">
                  <a:latin typeface="Arial" panose="020B0604020202020204" pitchFamily="34" charset="0"/>
                  <a:cs typeface="Arial" panose="020B0604020202020204" pitchFamily="34" charset="0"/>
                </a:rPr>
                <a:t>-A</a:t>
              </a:r>
              <a:endParaRPr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Shape 260"/>
            <p:cNvSpPr/>
            <p:nvPr/>
          </p:nvSpPr>
          <p:spPr>
            <a:xfrm>
              <a:off x="672517" y="3647236"/>
              <a:ext cx="569705" cy="540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bevel/>
              <a:tailEnd type="triangle" w="med" len="med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1200"/>
            </a:p>
          </p:txBody>
        </p:sp>
        <p:sp>
          <p:nvSpPr>
            <p:cNvPr id="261" name="Shape 261"/>
            <p:cNvSpPr/>
            <p:nvPr/>
          </p:nvSpPr>
          <p:spPr>
            <a:xfrm flipV="1">
              <a:off x="518205" y="284200"/>
              <a:ext cx="2" cy="3219286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bevel/>
              <a:tailEnd type="triangle" w="med" len="med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1200"/>
            </a:p>
          </p:txBody>
        </p:sp>
        <p:sp>
          <p:nvSpPr>
            <p:cNvPr id="262" name="Shape 262"/>
            <p:cNvSpPr/>
            <p:nvPr/>
          </p:nvSpPr>
          <p:spPr>
            <a:xfrm>
              <a:off x="2483039" y="3668097"/>
              <a:ext cx="685610" cy="6144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bevel/>
              <a:tailEnd type="triangle" w="med" len="med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1200"/>
            </a:p>
          </p:txBody>
        </p:sp>
        <p:sp>
          <p:nvSpPr>
            <p:cNvPr id="263" name="Shape 263"/>
            <p:cNvSpPr/>
            <p:nvPr/>
          </p:nvSpPr>
          <p:spPr>
            <a:xfrm>
              <a:off x="3219843" y="3496107"/>
              <a:ext cx="1043255" cy="3765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914400">
                <a:spcBef>
                  <a:spcPts val="700"/>
                </a:spcBef>
                <a:defRPr sz="12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dirty="0">
                  <a:latin typeface="Arial" panose="020B0604020202020204" pitchFamily="34" charset="0"/>
                  <a:cs typeface="Arial" panose="020B0604020202020204" pitchFamily="34" charset="0"/>
                </a:rPr>
                <a:t>NFL</a:t>
              </a:r>
            </a:p>
          </p:txBody>
        </p:sp>
        <p:sp>
          <p:nvSpPr>
            <p:cNvPr id="264" name="Shape 264"/>
            <p:cNvSpPr/>
            <p:nvPr/>
          </p:nvSpPr>
          <p:spPr>
            <a:xfrm>
              <a:off x="4639850" y="3454849"/>
              <a:ext cx="1043251" cy="3765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914400">
                <a:spcBef>
                  <a:spcPts val="700"/>
                </a:spcBef>
                <a:defRPr sz="12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lang="en-CA" dirty="0"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r>
                <a:rPr lang="en-CA" dirty="0" err="1">
                  <a:latin typeface="Arial" panose="020B0604020202020204" pitchFamily="34" charset="0"/>
                  <a:cs typeface="Arial" panose="020B0604020202020204" pitchFamily="34" charset="0"/>
                </a:rPr>
                <a:t>GzB</a:t>
              </a:r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Shape 265"/>
            <p:cNvSpPr/>
            <p:nvPr/>
          </p:nvSpPr>
          <p:spPr>
            <a:xfrm flipV="1">
              <a:off x="2335470" y="284200"/>
              <a:ext cx="2" cy="324881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bevel/>
              <a:tailEnd type="triangle" w="med" len="med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1200"/>
            </a:p>
          </p:txBody>
        </p:sp>
        <p:sp>
          <p:nvSpPr>
            <p:cNvPr id="266" name="Shape 266"/>
            <p:cNvSpPr/>
            <p:nvPr/>
          </p:nvSpPr>
          <p:spPr>
            <a:xfrm>
              <a:off x="4118221" y="3668098"/>
              <a:ext cx="483500" cy="74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bevel/>
              <a:tailEnd type="triangle" w="med" len="med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1200"/>
            </a:p>
          </p:txBody>
        </p:sp>
        <p:sp>
          <p:nvSpPr>
            <p:cNvPr id="267" name="Shape 267"/>
            <p:cNvSpPr/>
            <p:nvPr/>
          </p:nvSpPr>
          <p:spPr>
            <a:xfrm>
              <a:off x="2104733" y="-292117"/>
              <a:ext cx="774809" cy="45159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914400">
                <a:spcBef>
                  <a:spcPts val="700"/>
                </a:spcBef>
                <a:defRPr sz="12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1800" dirty="0">
                  <a:latin typeface="Arial" panose="020B0604020202020204" pitchFamily="34" charset="0"/>
                  <a:cs typeface="Arial" panose="020B0604020202020204" pitchFamily="34" charset="0"/>
                </a:rPr>
                <a:t>TFL</a:t>
              </a:r>
            </a:p>
          </p:txBody>
        </p:sp>
        <p:pic>
          <p:nvPicPr>
            <p:cNvPr id="268" name="image1.png"/>
            <p:cNvPicPr>
              <a:picLocks noChangeAspect="1"/>
            </p:cNvPicPr>
            <p:nvPr/>
          </p:nvPicPr>
          <p:blipFill>
            <a:blip r:embed="rId3">
              <a:extLst/>
            </a:blip>
            <a:srcRect l="16475" t="9304" r="4930" b="14247"/>
            <a:stretch>
              <a:fillRect/>
            </a:stretch>
          </p:blipFill>
          <p:spPr>
            <a:xfrm>
              <a:off x="654230" y="109207"/>
              <a:ext cx="1495635" cy="168736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269" name="Shape 269"/>
            <p:cNvSpPr/>
            <p:nvPr/>
          </p:nvSpPr>
          <p:spPr>
            <a:xfrm>
              <a:off x="1510334" y="620821"/>
              <a:ext cx="230398" cy="149244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t">
              <a:noAutofit/>
            </a:bodyPr>
            <a:lstStyle/>
            <a:p>
              <a:pPr defTabSz="642915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endParaRPr sz="700"/>
            </a:p>
          </p:txBody>
        </p:sp>
        <p:sp>
          <p:nvSpPr>
            <p:cNvPr id="270" name="Shape 270"/>
            <p:cNvSpPr/>
            <p:nvPr/>
          </p:nvSpPr>
          <p:spPr>
            <a:xfrm>
              <a:off x="1510334" y="620821"/>
              <a:ext cx="230398" cy="10943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0" tIns="0" rIns="0" bIns="0" numCol="1" anchor="t">
              <a:spAutoFit/>
            </a:bodyPr>
            <a:lstStyle>
              <a:lvl1pPr defTabSz="914400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500"/>
                <a:t>25.1</a:t>
              </a:r>
            </a:p>
          </p:txBody>
        </p:sp>
        <p:pic>
          <p:nvPicPr>
            <p:cNvPr id="271" name="image2.png"/>
            <p:cNvPicPr>
              <a:picLocks noChangeAspect="1"/>
            </p:cNvPicPr>
            <p:nvPr/>
          </p:nvPicPr>
          <p:blipFill>
            <a:blip r:embed="rId4">
              <a:extLst/>
            </a:blip>
            <a:srcRect l="17081" t="9314" r="4524" b="14855"/>
            <a:stretch>
              <a:fillRect/>
            </a:stretch>
          </p:blipFill>
          <p:spPr>
            <a:xfrm>
              <a:off x="654230" y="1845648"/>
              <a:ext cx="1495635" cy="168736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272" name="image3.png"/>
            <p:cNvPicPr>
              <a:picLocks noChangeAspect="1"/>
            </p:cNvPicPr>
            <p:nvPr/>
          </p:nvPicPr>
          <p:blipFill>
            <a:blip r:embed="rId5">
              <a:extLst/>
            </a:blip>
            <a:srcRect l="17002" t="9437" r="4858" b="15171"/>
            <a:stretch>
              <a:fillRect/>
            </a:stretch>
          </p:blipFill>
          <p:spPr>
            <a:xfrm>
              <a:off x="2483039" y="109206"/>
              <a:ext cx="1495635" cy="168736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273" name="image4.png"/>
            <p:cNvPicPr>
              <a:picLocks noChangeAspect="1"/>
            </p:cNvPicPr>
            <p:nvPr/>
          </p:nvPicPr>
          <p:blipFill>
            <a:blip r:embed="rId6">
              <a:extLst/>
            </a:blip>
            <a:srcRect l="16904" t="9705" r="4748" b="15519"/>
            <a:stretch>
              <a:fillRect/>
            </a:stretch>
          </p:blipFill>
          <p:spPr>
            <a:xfrm>
              <a:off x="2483039" y="1845648"/>
              <a:ext cx="1495635" cy="168736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274" name="Shape 274"/>
            <p:cNvSpPr/>
            <p:nvPr/>
          </p:nvSpPr>
          <p:spPr>
            <a:xfrm>
              <a:off x="1505623" y="2361496"/>
              <a:ext cx="230398" cy="149245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t">
              <a:noAutofit/>
            </a:bodyPr>
            <a:lstStyle/>
            <a:p>
              <a:pPr defTabSz="642915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endParaRPr sz="700"/>
            </a:p>
          </p:txBody>
        </p:sp>
        <p:sp>
          <p:nvSpPr>
            <p:cNvPr id="275" name="Shape 275"/>
            <p:cNvSpPr/>
            <p:nvPr/>
          </p:nvSpPr>
          <p:spPr>
            <a:xfrm>
              <a:off x="1505624" y="2361496"/>
              <a:ext cx="230398" cy="10943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0" tIns="0" rIns="0" bIns="0" numCol="1" anchor="t">
              <a:spAutoFit/>
            </a:bodyPr>
            <a:lstStyle>
              <a:lvl1pPr defTabSz="914400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500"/>
                <a:t>23.0</a:t>
              </a:r>
            </a:p>
          </p:txBody>
        </p:sp>
        <p:sp>
          <p:nvSpPr>
            <p:cNvPr id="276" name="Shape 276"/>
            <p:cNvSpPr/>
            <p:nvPr/>
          </p:nvSpPr>
          <p:spPr>
            <a:xfrm>
              <a:off x="2879545" y="284200"/>
              <a:ext cx="230398" cy="149244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t">
              <a:noAutofit/>
            </a:bodyPr>
            <a:lstStyle/>
            <a:p>
              <a:pPr defTabSz="642915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endParaRPr sz="700"/>
            </a:p>
          </p:txBody>
        </p:sp>
        <p:sp>
          <p:nvSpPr>
            <p:cNvPr id="277" name="Shape 277"/>
            <p:cNvSpPr/>
            <p:nvPr/>
          </p:nvSpPr>
          <p:spPr>
            <a:xfrm>
              <a:off x="2879545" y="284200"/>
              <a:ext cx="230398" cy="10943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0" tIns="0" rIns="0" bIns="0" numCol="1" anchor="t">
              <a:spAutoFit/>
            </a:bodyPr>
            <a:lstStyle>
              <a:lvl1pPr defTabSz="914400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500"/>
                <a:t>13.4</a:t>
              </a:r>
            </a:p>
          </p:txBody>
        </p:sp>
        <p:sp>
          <p:nvSpPr>
            <p:cNvPr id="278" name="Shape 278"/>
            <p:cNvSpPr/>
            <p:nvPr/>
          </p:nvSpPr>
          <p:spPr>
            <a:xfrm>
              <a:off x="2879545" y="2022783"/>
              <a:ext cx="230398" cy="149244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t">
              <a:noAutofit/>
            </a:bodyPr>
            <a:lstStyle/>
            <a:p>
              <a:pPr defTabSz="642915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endParaRPr sz="700"/>
            </a:p>
          </p:txBody>
        </p:sp>
        <p:sp>
          <p:nvSpPr>
            <p:cNvPr id="279" name="Shape 279"/>
            <p:cNvSpPr/>
            <p:nvPr/>
          </p:nvSpPr>
          <p:spPr>
            <a:xfrm>
              <a:off x="2879545" y="2022782"/>
              <a:ext cx="230398" cy="10943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0" tIns="0" rIns="0" bIns="0" numCol="1" anchor="t">
              <a:spAutoFit/>
            </a:bodyPr>
            <a:lstStyle>
              <a:lvl1pPr defTabSz="914400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500"/>
                <a:t>12.4</a:t>
              </a:r>
            </a:p>
          </p:txBody>
        </p:sp>
        <p:pic>
          <p:nvPicPr>
            <p:cNvPr id="280" name="image5.png"/>
            <p:cNvPicPr>
              <a:picLocks noChangeAspect="1"/>
            </p:cNvPicPr>
            <p:nvPr/>
          </p:nvPicPr>
          <p:blipFill>
            <a:blip r:embed="rId7">
              <a:extLst/>
            </a:blip>
            <a:srcRect l="17535" t="9535" r="4488" b="14924"/>
            <a:stretch>
              <a:fillRect/>
            </a:stretch>
          </p:blipFill>
          <p:spPr>
            <a:xfrm>
              <a:off x="4076799" y="109206"/>
              <a:ext cx="1495637" cy="168736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281" name="image6.png"/>
            <p:cNvPicPr>
              <a:picLocks noChangeAspect="1"/>
            </p:cNvPicPr>
            <p:nvPr/>
          </p:nvPicPr>
          <p:blipFill>
            <a:blip r:embed="rId8">
              <a:extLst/>
            </a:blip>
            <a:srcRect l="17332" t="9106" r="4519" b="14887"/>
            <a:stretch>
              <a:fillRect/>
            </a:stretch>
          </p:blipFill>
          <p:spPr>
            <a:xfrm>
              <a:off x="4076799" y="1845648"/>
              <a:ext cx="1495636" cy="168736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282" name="Shape 282"/>
            <p:cNvSpPr/>
            <p:nvPr/>
          </p:nvSpPr>
          <p:spPr>
            <a:xfrm>
              <a:off x="4226792" y="333633"/>
              <a:ext cx="230397" cy="149244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t">
              <a:noAutofit/>
            </a:bodyPr>
            <a:lstStyle/>
            <a:p>
              <a:pPr defTabSz="642915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endParaRPr sz="700"/>
            </a:p>
          </p:txBody>
        </p:sp>
        <p:sp>
          <p:nvSpPr>
            <p:cNvPr id="283" name="Shape 283"/>
            <p:cNvSpPr/>
            <p:nvPr/>
          </p:nvSpPr>
          <p:spPr>
            <a:xfrm>
              <a:off x="4226792" y="333633"/>
              <a:ext cx="230397" cy="10943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0" tIns="0" rIns="0" bIns="0" numCol="1" anchor="t">
              <a:spAutoFit/>
            </a:bodyPr>
            <a:lstStyle>
              <a:lvl1pPr defTabSz="914400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500"/>
                <a:t>98.6</a:t>
              </a:r>
            </a:p>
          </p:txBody>
        </p:sp>
        <p:sp>
          <p:nvSpPr>
            <p:cNvPr id="284" name="Shape 284"/>
            <p:cNvSpPr/>
            <p:nvPr/>
          </p:nvSpPr>
          <p:spPr>
            <a:xfrm>
              <a:off x="4226792" y="2072218"/>
              <a:ext cx="230397" cy="149244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t">
              <a:noAutofit/>
            </a:bodyPr>
            <a:lstStyle/>
            <a:p>
              <a:pPr defTabSz="642915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endParaRPr sz="700"/>
            </a:p>
          </p:txBody>
        </p:sp>
        <p:sp>
          <p:nvSpPr>
            <p:cNvPr id="285" name="Shape 285"/>
            <p:cNvSpPr/>
            <p:nvPr/>
          </p:nvSpPr>
          <p:spPr>
            <a:xfrm>
              <a:off x="4226792" y="2072217"/>
              <a:ext cx="230397" cy="10943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0" tIns="0" rIns="0" bIns="0" numCol="1" anchor="t">
              <a:spAutoFit/>
            </a:bodyPr>
            <a:lstStyle>
              <a:lvl1pPr defTabSz="914400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500"/>
                <a:t>76.3</a:t>
              </a:r>
            </a:p>
          </p:txBody>
        </p:sp>
        <p:sp>
          <p:nvSpPr>
            <p:cNvPr id="286" name="Shape 286"/>
            <p:cNvSpPr/>
            <p:nvPr/>
          </p:nvSpPr>
          <p:spPr>
            <a:xfrm>
              <a:off x="5279626" y="329491"/>
              <a:ext cx="230397" cy="149244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t">
              <a:noAutofit/>
            </a:bodyPr>
            <a:lstStyle/>
            <a:p>
              <a:pPr defTabSz="642915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endParaRPr sz="700"/>
            </a:p>
          </p:txBody>
        </p:sp>
        <p:sp>
          <p:nvSpPr>
            <p:cNvPr id="287" name="Shape 287"/>
            <p:cNvSpPr/>
            <p:nvPr/>
          </p:nvSpPr>
          <p:spPr>
            <a:xfrm>
              <a:off x="5279625" y="329492"/>
              <a:ext cx="230397" cy="10943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0" tIns="0" rIns="0" bIns="0" numCol="1" anchor="t">
              <a:spAutoFit/>
            </a:bodyPr>
            <a:lstStyle>
              <a:lvl1pPr defTabSz="914400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500"/>
                <a:t>1.4</a:t>
              </a:r>
            </a:p>
          </p:txBody>
        </p:sp>
        <p:sp>
          <p:nvSpPr>
            <p:cNvPr id="288" name="Shape 288"/>
            <p:cNvSpPr/>
            <p:nvPr/>
          </p:nvSpPr>
          <p:spPr>
            <a:xfrm>
              <a:off x="5279626" y="2068075"/>
              <a:ext cx="230397" cy="149245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t">
              <a:noAutofit/>
            </a:bodyPr>
            <a:lstStyle/>
            <a:p>
              <a:pPr defTabSz="642915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endParaRPr sz="700"/>
            </a:p>
          </p:txBody>
        </p:sp>
        <p:sp>
          <p:nvSpPr>
            <p:cNvPr id="289" name="Shape 289"/>
            <p:cNvSpPr/>
            <p:nvPr/>
          </p:nvSpPr>
          <p:spPr>
            <a:xfrm>
              <a:off x="5279625" y="2068074"/>
              <a:ext cx="230397" cy="10943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0" tIns="0" rIns="0" bIns="0" numCol="1" anchor="t">
              <a:spAutoFit/>
            </a:bodyPr>
            <a:lstStyle>
              <a:lvl1pPr defTabSz="914400">
                <a:defRPr sz="7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>
                <a:defRPr sz="1800"/>
              </a:pPr>
              <a:r>
                <a:rPr sz="500"/>
                <a:t>23.7</a:t>
              </a:r>
            </a:p>
          </p:txBody>
        </p:sp>
      </p:grpSp>
      <p:sp>
        <p:nvSpPr>
          <p:cNvPr id="291" name="Shape 291"/>
          <p:cNvSpPr/>
          <p:nvPr/>
        </p:nvSpPr>
        <p:spPr>
          <a:xfrm>
            <a:off x="355536" y="323478"/>
            <a:ext cx="1223644" cy="27699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0" tIns="0" rIns="0" bIns="0" anchor="ctr">
            <a:spAutoFit/>
          </a:bodyPr>
          <a:lstStyle>
            <a:lvl1pPr defTabSz="914400"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800" dirty="0"/>
              <a:t>Figure S1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3A366D34-3C39-4F25-8349-ACAEA4645658}"/>
              </a:ext>
            </a:extLst>
          </p:cNvPr>
          <p:cNvCxnSpPr>
            <a:cxnSpLocks/>
          </p:cNvCxnSpPr>
          <p:nvPr/>
        </p:nvCxnSpPr>
        <p:spPr>
          <a:xfrm>
            <a:off x="2754075" y="2922836"/>
            <a:ext cx="628657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82325525-8D4D-4818-849A-AE8AAAA0D69B}"/>
              </a:ext>
            </a:extLst>
          </p:cNvPr>
          <p:cNvCxnSpPr>
            <a:cxnSpLocks/>
          </p:cNvCxnSpPr>
          <p:nvPr/>
        </p:nvCxnSpPr>
        <p:spPr>
          <a:xfrm flipV="1">
            <a:off x="3808957" y="2914968"/>
            <a:ext cx="1237799" cy="786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7C4A499F-91E3-469C-B627-0886FC186906}"/>
              </a:ext>
            </a:extLst>
          </p:cNvPr>
          <p:cNvSpPr txBox="1"/>
          <p:nvPr/>
        </p:nvSpPr>
        <p:spPr>
          <a:xfrm>
            <a:off x="1665598" y="4854649"/>
            <a:ext cx="844771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ting strategy for ADCC-GTL assay and correlation of %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 CEM target cells generated in an ADCC-GTL assay with gp120 coated CEM target cell los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) CEM.NKr.CCR5 (CEM) target cells coated with recombinant gp120 HIV Envelope were gated on in the forward scatter (FSC-A) and side scatter (SSC-A) gates based on samples with only target cells (not shown). From this gate, target cells (NFL1-TFL4+) incubated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bstrate were identified. Release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activated NK effector cells resulted in target cell fluorescence. The %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uorescent target cells was compared in the absence (upper panels, IgG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versus presence (lower panels, IgG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of  a source of anti-HIV gp120 specific antibody (HIVIG or IgG). %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ells in the presence of IgG was background-corrected against %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ells in the absence of IgG. (B) Correlation between the %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EM cells generated in the ADCC-GTL assay versus gp120 coated CEM cell loss in the presence of HIVIG and PBMC effector cells due to ADCC activity (r = 0.58, p = 0.07). 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CA6BE884-D77F-4B4C-A378-0B33CCFB7077}"/>
              </a:ext>
            </a:extLst>
          </p:cNvPr>
          <p:cNvCxnSpPr>
            <a:cxnSpLocks/>
          </p:cNvCxnSpPr>
          <p:nvPr/>
        </p:nvCxnSpPr>
        <p:spPr>
          <a:xfrm>
            <a:off x="2619188" y="1527154"/>
            <a:ext cx="76354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4E70FF83-81F0-484C-B110-44F6AEA9F59F}"/>
              </a:ext>
            </a:extLst>
          </p:cNvPr>
          <p:cNvCxnSpPr>
            <a:cxnSpLocks/>
          </p:cNvCxnSpPr>
          <p:nvPr/>
        </p:nvCxnSpPr>
        <p:spPr>
          <a:xfrm>
            <a:off x="3759812" y="1533544"/>
            <a:ext cx="129874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8E925958-C854-4E1E-A743-8392813CA4D7}"/>
              </a:ext>
            </a:extLst>
          </p:cNvPr>
          <p:cNvSpPr txBox="1"/>
          <p:nvPr/>
        </p:nvSpPr>
        <p:spPr>
          <a:xfrm>
            <a:off x="1102504" y="981828"/>
            <a:ext cx="39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6AA953F-C3D4-4CB4-82CE-924580FA831F}"/>
              </a:ext>
            </a:extLst>
          </p:cNvPr>
          <p:cNvSpPr txBox="1"/>
          <p:nvPr/>
        </p:nvSpPr>
        <p:spPr>
          <a:xfrm>
            <a:off x="6561023" y="981828"/>
            <a:ext cx="39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B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9BC29E9-B073-4B1F-829E-D60C85D354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4876313"/>
              </p:ext>
            </p:extLst>
          </p:nvPr>
        </p:nvGraphicFramePr>
        <p:xfrm>
          <a:off x="6396015" y="1180906"/>
          <a:ext cx="4485725" cy="3149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6" r:id="rId9" imgW="3777824" imgH="2652895" progId="Prism6.Document">
                  <p:embed/>
                </p:oleObj>
              </mc:Choice>
              <mc:Fallback>
                <p:oleObj name="Prism 6" r:id="rId9" imgW="3777824" imgH="265289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396015" y="1180906"/>
                        <a:ext cx="4485725" cy="31494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47271128"/>
      </p:ext>
    </p:extLst>
  </p:cSld>
  <p:clrMapOvr>
    <a:masterClrMapping/>
  </p:clrMapOvr>
  <p:transition spd="slow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97284" y="5479829"/>
            <a:ext cx="8534400" cy="1295400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: Gating strategy used to isolate NK cells that are single positive for inhibitory NK receptors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PiNKR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om live, singlet CD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K cells were gated on (top panels). In the 2nd left hand row CD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‑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K cells were separated into those that were KIR3DL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3DL1) NKG2A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‑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NKG2a) (box A) and 3DL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KG2a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box B). From box A cells negative for KIR2DL1 (2DL1) and KIR2DL3 (2DL3) were designated as SP3DL1. From box B cells negative for 2DL1 and 2DL3 were designated as SPNKG2a. In the bottom left-hand panel CD5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K cells were separated into those that were 2DL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DL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box C) and 2DL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DL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box D). From Box C cells negative for 3DL1 and NKG2a were designated as SP2DL3+. From box D cells negative for 3DL1 and NKG2A were designated as SP2DL1. (B) Examples of intracellular f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perforin within each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PiNK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K cell subset. (C) Staining f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Gz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 pink and its isotype control in blue. (D) Staining for perforin in pink 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and it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MO in blue.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964484" y="1189332"/>
            <a:ext cx="129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B) % </a:t>
            </a:r>
            <a:r>
              <a:rPr lang="en-US" sz="800" dirty="0" err="1"/>
              <a:t>GzB+Perforin</a:t>
            </a:r>
            <a:r>
              <a:rPr lang="en-US" sz="8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031066" y="1228429"/>
            <a:ext cx="10668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Gated on CD56</a:t>
            </a:r>
            <a:r>
              <a:rPr lang="en-US" sz="700" baseline="30000" dirty="0"/>
              <a:t>di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207638" y="1433671"/>
            <a:ext cx="2564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560358" y="1804978"/>
            <a:ext cx="2564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06069" y="3328978"/>
            <a:ext cx="2564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641474" y="3667561"/>
            <a:ext cx="2564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215511" y="1238238"/>
            <a:ext cx="6096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Gated on A</a:t>
            </a:r>
            <a:endParaRPr lang="en-US" sz="700" baseline="30000" dirty="0"/>
          </a:p>
        </p:txBody>
      </p:sp>
      <p:sp>
        <p:nvSpPr>
          <p:cNvPr id="17" name="TextBox 16"/>
          <p:cNvSpPr txBox="1"/>
          <p:nvPr/>
        </p:nvSpPr>
        <p:spPr>
          <a:xfrm>
            <a:off x="4213958" y="2227523"/>
            <a:ext cx="6096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Gated on B</a:t>
            </a:r>
            <a:endParaRPr lang="en-US" sz="700" baseline="30000" dirty="0"/>
          </a:p>
        </p:txBody>
      </p:sp>
      <p:sp>
        <p:nvSpPr>
          <p:cNvPr id="18" name="TextBox 17"/>
          <p:cNvSpPr txBox="1"/>
          <p:nvPr/>
        </p:nvSpPr>
        <p:spPr>
          <a:xfrm>
            <a:off x="4220224" y="3206707"/>
            <a:ext cx="6096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Gated on C</a:t>
            </a:r>
            <a:endParaRPr lang="en-US" sz="700" baseline="30000" dirty="0"/>
          </a:p>
        </p:txBody>
      </p:sp>
      <p:sp>
        <p:nvSpPr>
          <p:cNvPr id="19" name="TextBox 18"/>
          <p:cNvSpPr txBox="1"/>
          <p:nvPr/>
        </p:nvSpPr>
        <p:spPr>
          <a:xfrm>
            <a:off x="4224940" y="4240755"/>
            <a:ext cx="6096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Gated on D</a:t>
            </a:r>
            <a:endParaRPr lang="en-US" sz="700" baseline="30000" dirty="0"/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A4C7AA47-1B59-42F6-8481-EE466F2E8636}"/>
              </a:ext>
            </a:extLst>
          </p:cNvPr>
          <p:cNvGrpSpPr/>
          <p:nvPr/>
        </p:nvGrpSpPr>
        <p:grpSpPr>
          <a:xfrm>
            <a:off x="2946674" y="457200"/>
            <a:ext cx="4597126" cy="5069914"/>
            <a:chOff x="1171079" y="250214"/>
            <a:chExt cx="4597126" cy="5069914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12" t="25103" r="56597" b="17652"/>
            <a:stretch/>
          </p:blipFill>
          <p:spPr bwMode="auto">
            <a:xfrm>
              <a:off x="1171079" y="290928"/>
              <a:ext cx="4597126" cy="5029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1638311" y="250214"/>
              <a:ext cx="9220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Lymphocyte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672168" y="261770"/>
              <a:ext cx="8382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Single  cells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811730" y="260923"/>
              <a:ext cx="5129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Live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41853" y="261333"/>
              <a:ext cx="6653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CD56</a:t>
              </a:r>
              <a:r>
                <a:rPr lang="en-US" sz="700" baseline="30000" dirty="0"/>
                <a:t>dim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575949" y="1624878"/>
              <a:ext cx="609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el"/>
                </a:rPr>
                <a:t>SP3DL1</a:t>
              </a:r>
              <a:endParaRPr lang="en-US" sz="1000" baseline="30000" dirty="0">
                <a:latin typeface="Arie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562312" y="2605473"/>
              <a:ext cx="6971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 </a:t>
              </a:r>
              <a:r>
                <a:rPr lang="en-US" sz="1000" dirty="0">
                  <a:latin typeface="Ariel"/>
                </a:rPr>
                <a:t>SPNKG2a</a:t>
              </a:r>
              <a:endParaRPr lang="en-US" sz="1000" baseline="30000" dirty="0">
                <a:latin typeface="Arie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589907" y="3565843"/>
              <a:ext cx="609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el"/>
                </a:rPr>
                <a:t>SP2DL3</a:t>
              </a:r>
              <a:endParaRPr lang="en-US" sz="1000" baseline="30000" dirty="0">
                <a:latin typeface="Ariel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98543" y="4576847"/>
              <a:ext cx="609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el"/>
                </a:rPr>
                <a:t>SP2DL1</a:t>
              </a:r>
              <a:endParaRPr lang="en-US" sz="1000" baseline="30000" dirty="0">
                <a:latin typeface="Ariel"/>
              </a:endParaRPr>
            </a:p>
          </p:txBody>
        </p:sp>
        <p:cxnSp>
          <p:nvCxnSpPr>
            <p:cNvPr id="24" name="Straight Arrow Connector 23"/>
            <p:cNvCxnSpPr/>
            <p:nvPr/>
          </p:nvCxnSpPr>
          <p:spPr>
            <a:xfrm>
              <a:off x="3348252" y="1738995"/>
              <a:ext cx="320523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4059182" y="1738995"/>
              <a:ext cx="320523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2164600" y="947925"/>
              <a:ext cx="36576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>
              <a:off x="3196552" y="929857"/>
              <a:ext cx="36576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>
              <a:off x="4217879" y="929857"/>
              <a:ext cx="36576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/>
            <p:nvPr/>
          </p:nvCxnSpPr>
          <p:spPr>
            <a:xfrm>
              <a:off x="3352965" y="2705500"/>
              <a:ext cx="320523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>
              <a:off x="4136036" y="2705500"/>
              <a:ext cx="320523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>
              <a:off x="3352137" y="3691387"/>
              <a:ext cx="320523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>
              <a:off x="4072493" y="3691387"/>
              <a:ext cx="320523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/>
            <p:cNvCxnSpPr/>
            <p:nvPr/>
          </p:nvCxnSpPr>
          <p:spPr>
            <a:xfrm>
              <a:off x="4084293" y="4697791"/>
              <a:ext cx="320523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/>
            <p:nvPr/>
          </p:nvCxnSpPr>
          <p:spPr>
            <a:xfrm>
              <a:off x="3341270" y="4714977"/>
              <a:ext cx="320523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34" t="25926" r="63402" b="44696"/>
          <a:stretch/>
        </p:blipFill>
        <p:spPr bwMode="auto">
          <a:xfrm>
            <a:off x="7937714" y="1025472"/>
            <a:ext cx="1759272" cy="36504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8DD3D6C-30DC-4F3B-B93E-DD05C1F43008}"/>
              </a:ext>
            </a:extLst>
          </p:cNvPr>
          <p:cNvSpPr txBox="1"/>
          <p:nvPr/>
        </p:nvSpPr>
        <p:spPr>
          <a:xfrm>
            <a:off x="1684844" y="148215"/>
            <a:ext cx="1059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S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E48526A-1A65-4975-96C6-009DE1646A6D}"/>
              </a:ext>
            </a:extLst>
          </p:cNvPr>
          <p:cNvSpPr txBox="1"/>
          <p:nvPr/>
        </p:nvSpPr>
        <p:spPr>
          <a:xfrm>
            <a:off x="3112545" y="170535"/>
            <a:ext cx="256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8D2E1FB-A22E-4DC4-B584-659A0C349CF8}"/>
              </a:ext>
            </a:extLst>
          </p:cNvPr>
          <p:cNvSpPr txBox="1"/>
          <p:nvPr/>
        </p:nvSpPr>
        <p:spPr>
          <a:xfrm>
            <a:off x="6093949" y="1397637"/>
            <a:ext cx="3205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14576B0-34A7-46C1-A1D2-21289CF885AB}"/>
              </a:ext>
            </a:extLst>
          </p:cNvPr>
          <p:cNvSpPr txBox="1"/>
          <p:nvPr/>
        </p:nvSpPr>
        <p:spPr>
          <a:xfrm>
            <a:off x="7722233" y="172033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BC03ACB-B140-44C5-966E-870968628D50}"/>
              </a:ext>
            </a:extLst>
          </p:cNvPr>
          <p:cNvSpPr txBox="1"/>
          <p:nvPr/>
        </p:nvSpPr>
        <p:spPr>
          <a:xfrm>
            <a:off x="7666307" y="326223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D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EE98FC3-05B5-40DA-BD9A-D8BF19CCFD31}"/>
              </a:ext>
            </a:extLst>
          </p:cNvPr>
          <p:cNvSpPr txBox="1"/>
          <p:nvPr/>
        </p:nvSpPr>
        <p:spPr>
          <a:xfrm>
            <a:off x="3452126" y="1649526"/>
            <a:ext cx="2584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D521FF8-222E-40A7-A4F3-686BD5044884}"/>
              </a:ext>
            </a:extLst>
          </p:cNvPr>
          <p:cNvSpPr txBox="1"/>
          <p:nvPr/>
        </p:nvSpPr>
        <p:spPr>
          <a:xfrm>
            <a:off x="3790926" y="1988369"/>
            <a:ext cx="2584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E8C11F7-5B60-497D-AD8B-953FDDF24713}"/>
              </a:ext>
            </a:extLst>
          </p:cNvPr>
          <p:cNvSpPr txBox="1"/>
          <p:nvPr/>
        </p:nvSpPr>
        <p:spPr>
          <a:xfrm>
            <a:off x="4371166" y="1436145"/>
            <a:ext cx="831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>
                <a:latin typeface="Ariel"/>
              </a:rPr>
              <a:t>Gated on 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E23FD40-1CD5-4685-BD5E-AB6CD180F9C3}"/>
              </a:ext>
            </a:extLst>
          </p:cNvPr>
          <p:cNvSpPr txBox="1"/>
          <p:nvPr/>
        </p:nvSpPr>
        <p:spPr>
          <a:xfrm>
            <a:off x="4371166" y="2397479"/>
            <a:ext cx="831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>
                <a:latin typeface="Ariel"/>
              </a:rPr>
              <a:t>Gated on B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3F85F80-1C8B-449D-89CA-CCAF1F86ACFF}"/>
              </a:ext>
            </a:extLst>
          </p:cNvPr>
          <p:cNvSpPr txBox="1"/>
          <p:nvPr/>
        </p:nvSpPr>
        <p:spPr>
          <a:xfrm>
            <a:off x="4383655" y="3405922"/>
            <a:ext cx="831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>
                <a:latin typeface="Ariel"/>
              </a:rPr>
              <a:t>Gated on C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8FCA551-04ED-441C-A79D-7E869BF58970}"/>
              </a:ext>
            </a:extLst>
          </p:cNvPr>
          <p:cNvSpPr txBox="1"/>
          <p:nvPr/>
        </p:nvSpPr>
        <p:spPr>
          <a:xfrm>
            <a:off x="3435179" y="3543083"/>
            <a:ext cx="2584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859DE33-6B78-4F8F-9311-6D617711D517}"/>
              </a:ext>
            </a:extLst>
          </p:cNvPr>
          <p:cNvSpPr txBox="1"/>
          <p:nvPr/>
        </p:nvSpPr>
        <p:spPr>
          <a:xfrm>
            <a:off x="3897960" y="3898374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4617531-BD77-4A60-82C0-D88CF2757258}"/>
              </a:ext>
            </a:extLst>
          </p:cNvPr>
          <p:cNvSpPr txBox="1"/>
          <p:nvPr/>
        </p:nvSpPr>
        <p:spPr>
          <a:xfrm>
            <a:off x="4405985" y="4428214"/>
            <a:ext cx="831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>
                <a:latin typeface="Ariel"/>
              </a:rPr>
              <a:t>Gated on 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82FA1AC-C227-454E-8C71-ED789BDD0858}"/>
              </a:ext>
            </a:extLst>
          </p:cNvPr>
          <p:cNvSpPr txBox="1"/>
          <p:nvPr/>
        </p:nvSpPr>
        <p:spPr>
          <a:xfrm>
            <a:off x="8455829" y="918070"/>
            <a:ext cx="831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err="1">
                <a:latin typeface="Ariel"/>
              </a:rPr>
              <a:t>GzB</a:t>
            </a:r>
            <a:r>
              <a:rPr lang="en-CA" sz="1000" dirty="0">
                <a:latin typeface="Ariel"/>
              </a:rPr>
              <a:t> staining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ACD8DC1-E0F1-44E9-9A34-A90BAA462392}"/>
              </a:ext>
            </a:extLst>
          </p:cNvPr>
          <p:cNvSpPr txBox="1"/>
          <p:nvPr/>
        </p:nvSpPr>
        <p:spPr>
          <a:xfrm>
            <a:off x="8305801" y="2742404"/>
            <a:ext cx="1066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>
                <a:latin typeface="Ariel"/>
              </a:rPr>
              <a:t>Perforin staining</a:t>
            </a:r>
          </a:p>
        </p:txBody>
      </p:sp>
    </p:spTree>
    <p:extLst>
      <p:ext uri="{BB962C8B-B14F-4D97-AF65-F5344CB8AC3E}">
        <p14:creationId xmlns:p14="http://schemas.microsoft.com/office/powerpoint/2010/main" val="20381189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60CFD1B-8657-4A6D-820B-0E0D064337D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02026" y="1585914"/>
          <a:ext cx="5186363" cy="3686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6" r:id="rId3" imgW="5186675" imgH="3686537" progId="Prism6.Document">
                  <p:embed/>
                </p:oleObj>
              </mc:Choice>
              <mc:Fallback>
                <p:oleObj name="Prism 6" r:id="rId3" imgW="5186675" imgH="3686537" progId="Prism6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60CFD1B-8657-4A6D-820B-0E0D064337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02026" y="1585914"/>
                        <a:ext cx="5186363" cy="3686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214238B-9D8D-490E-9BFE-DA2C9397267A}"/>
              </a:ext>
            </a:extLst>
          </p:cNvPr>
          <p:cNvSpPr txBox="1"/>
          <p:nvPr/>
        </p:nvSpPr>
        <p:spPr>
          <a:xfrm>
            <a:off x="2590800" y="5562600"/>
            <a:ext cx="6934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Isolated NK cells were used as effector cells (E) in ADCC-GTL assays using gp120 coated opsonized CEM cells as targets (T) at different E:Ts. </a:t>
            </a:r>
          </a:p>
        </p:txBody>
      </p:sp>
    </p:spTree>
    <p:extLst>
      <p:ext uri="{BB962C8B-B14F-4D97-AF65-F5344CB8AC3E}">
        <p14:creationId xmlns:p14="http://schemas.microsoft.com/office/powerpoint/2010/main" val="42672535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Shape 259"/>
          <p:cNvSpPr/>
          <p:nvPr/>
        </p:nvSpPr>
        <p:spPr>
          <a:xfrm>
            <a:off x="8318560" y="3163359"/>
            <a:ext cx="503567" cy="139208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2145" tIns="32145" rIns="32145" bIns="32145" numCol="1" anchor="t">
            <a:noAutofit/>
          </a:bodyPr>
          <a:lstStyle/>
          <a:p>
            <a:pPr defTabSz="642915">
              <a:defRPr sz="1800">
                <a:latin typeface="Arial"/>
                <a:ea typeface="Arial"/>
                <a:cs typeface="Arial"/>
                <a:sym typeface="Arial"/>
              </a:defRPr>
            </a:pPr>
            <a:endParaRPr sz="1266"/>
          </a:p>
        </p:txBody>
      </p:sp>
      <p:sp>
        <p:nvSpPr>
          <p:cNvPr id="50" name="Shape 264"/>
          <p:cNvSpPr/>
          <p:nvPr/>
        </p:nvSpPr>
        <p:spPr>
          <a:xfrm>
            <a:off x="9393380" y="3164062"/>
            <a:ext cx="420272" cy="109219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2145" tIns="32145" rIns="32145" bIns="32145" numCol="1" anchor="t">
            <a:noAutofit/>
          </a:bodyPr>
          <a:lstStyle/>
          <a:p>
            <a:pPr defTabSz="642915">
              <a:defRPr sz="1800">
                <a:latin typeface="Arial"/>
                <a:ea typeface="Arial"/>
                <a:cs typeface="Arial"/>
                <a:sym typeface="Arial"/>
              </a:defRPr>
            </a:pPr>
            <a:endParaRPr sz="1266"/>
          </a:p>
        </p:txBody>
      </p:sp>
      <p:sp>
        <p:nvSpPr>
          <p:cNvPr id="49" name="Shape 268"/>
          <p:cNvSpPr/>
          <p:nvPr/>
        </p:nvSpPr>
        <p:spPr>
          <a:xfrm rot="16200000">
            <a:off x="8902681" y="2523409"/>
            <a:ext cx="404745" cy="1413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ctr">
            <a:noAutofit/>
          </a:bodyPr>
          <a:lstStyle>
            <a:lvl1pPr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>
              <a:defRPr sz="1800"/>
            </a:pPr>
            <a:r>
              <a:rPr sz="844" dirty="0"/>
              <a:t>IFN-γ</a:t>
            </a:r>
          </a:p>
        </p:txBody>
      </p:sp>
      <p:sp>
        <p:nvSpPr>
          <p:cNvPr id="88" name="Shape 294"/>
          <p:cNvSpPr/>
          <p:nvPr/>
        </p:nvSpPr>
        <p:spPr>
          <a:xfrm>
            <a:off x="8373822" y="4446220"/>
            <a:ext cx="471626" cy="138883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2145" tIns="32145" rIns="32145" bIns="32145" numCol="1" anchor="t">
            <a:noAutofit/>
          </a:bodyPr>
          <a:lstStyle/>
          <a:p>
            <a:pPr defTabSz="642915">
              <a:defRPr sz="1800">
                <a:latin typeface="Arial"/>
                <a:ea typeface="Arial"/>
                <a:cs typeface="Arial"/>
                <a:sym typeface="Arial"/>
              </a:defRPr>
            </a:pPr>
            <a:endParaRPr sz="1266"/>
          </a:p>
        </p:txBody>
      </p:sp>
      <p:sp>
        <p:nvSpPr>
          <p:cNvPr id="86" name="Shape 299"/>
          <p:cNvSpPr/>
          <p:nvPr/>
        </p:nvSpPr>
        <p:spPr>
          <a:xfrm>
            <a:off x="9428221" y="4454667"/>
            <a:ext cx="394876" cy="109210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</p:spPr>
        <p:txBody>
          <a:bodyPr wrap="square" lIns="32145" tIns="32145" rIns="32145" bIns="32145" numCol="1" anchor="t">
            <a:noAutofit/>
          </a:bodyPr>
          <a:lstStyle/>
          <a:p>
            <a:pPr defTabSz="642915">
              <a:defRPr sz="1800">
                <a:latin typeface="Arial"/>
                <a:ea typeface="Arial"/>
                <a:cs typeface="Arial"/>
                <a:sym typeface="Arial"/>
              </a:defRPr>
            </a:pPr>
            <a:endParaRPr sz="1266"/>
          </a:p>
        </p:txBody>
      </p:sp>
      <p:sp>
        <p:nvSpPr>
          <p:cNvPr id="109" name="Shape 349"/>
          <p:cNvSpPr/>
          <p:nvPr/>
        </p:nvSpPr>
        <p:spPr>
          <a:xfrm rot="10800000" flipV="1">
            <a:off x="2240288" y="1178492"/>
            <a:ext cx="169948" cy="1514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ctr">
            <a:spAutoFit/>
          </a:bodyPr>
          <a:lstStyle>
            <a:lvl1pPr>
              <a:defRPr sz="14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984" dirty="0"/>
              <a:t>A.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0DAA32F-39C4-467E-A315-F24DCDAE9C48}"/>
              </a:ext>
            </a:extLst>
          </p:cNvPr>
          <p:cNvGrpSpPr/>
          <p:nvPr/>
        </p:nvGrpSpPr>
        <p:grpSpPr>
          <a:xfrm>
            <a:off x="7800907" y="2042959"/>
            <a:ext cx="2212571" cy="2628958"/>
            <a:chOff x="7811507" y="1967007"/>
            <a:chExt cx="2212571" cy="2628958"/>
          </a:xfrm>
        </p:grpSpPr>
        <p:sp>
          <p:nvSpPr>
            <p:cNvPr id="53" name="Shape 260"/>
            <p:cNvSpPr/>
            <p:nvPr/>
          </p:nvSpPr>
          <p:spPr>
            <a:xfrm>
              <a:off x="8383688" y="3171501"/>
              <a:ext cx="503567" cy="14130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t">
              <a:noAutofit/>
            </a:bodyPr>
            <a:lstStyle>
              <a:lvl1pPr defTabSz="914400">
                <a:defRPr sz="12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>
                <a:defRPr sz="1800"/>
              </a:pPr>
              <a:r>
                <a:rPr sz="844" dirty="0"/>
                <a:t>CD107a</a:t>
              </a:r>
            </a:p>
          </p:txBody>
        </p:sp>
        <p:sp>
          <p:nvSpPr>
            <p:cNvPr id="21" name="Shape 262"/>
            <p:cNvSpPr/>
            <p:nvPr/>
          </p:nvSpPr>
          <p:spPr>
            <a:xfrm>
              <a:off x="7811507" y="2183824"/>
              <a:ext cx="286922" cy="12151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ctr">
              <a:noAutofit/>
            </a:bodyPr>
            <a:lstStyle/>
            <a:p>
              <a:pPr defTabSz="642915">
                <a:defRPr sz="1800">
                  <a:latin typeface="Arial"/>
                  <a:ea typeface="Arial"/>
                  <a:cs typeface="Arial"/>
                  <a:sym typeface="Arial"/>
                </a:defRPr>
              </a:pPr>
              <a:r>
                <a:rPr sz="844" b="1" dirty="0"/>
                <a:t>IgG</a:t>
              </a:r>
              <a:r>
                <a:rPr sz="844" b="1" baseline="31999" dirty="0"/>
                <a:t>-</a:t>
              </a:r>
            </a:p>
          </p:txBody>
        </p:sp>
        <p:sp>
          <p:nvSpPr>
            <p:cNvPr id="51" name="Shape 265"/>
            <p:cNvSpPr/>
            <p:nvPr/>
          </p:nvSpPr>
          <p:spPr>
            <a:xfrm>
              <a:off x="9458508" y="3164062"/>
              <a:ext cx="420272" cy="14130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t">
              <a:noAutofit/>
            </a:bodyPr>
            <a:lstStyle>
              <a:lvl1pPr defTabSz="914400">
                <a:defRPr sz="12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>
                <a:defRPr sz="1800"/>
              </a:pPr>
              <a:r>
                <a:rPr sz="844" dirty="0"/>
                <a:t>CCL4</a:t>
              </a:r>
            </a:p>
          </p:txBody>
        </p:sp>
        <p:sp>
          <p:nvSpPr>
            <p:cNvPr id="48" name="Shape 267"/>
            <p:cNvSpPr/>
            <p:nvPr/>
          </p:nvSpPr>
          <p:spPr>
            <a:xfrm rot="16200000">
              <a:off x="8927104" y="2595420"/>
              <a:ext cx="404745" cy="143827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32145" tIns="32145" rIns="32145" bIns="32145" numCol="1" anchor="ctr">
              <a:noAutofit/>
            </a:bodyPr>
            <a:lstStyle/>
            <a:p>
              <a:pPr defTabSz="642915">
                <a:defRPr sz="1800">
                  <a:latin typeface="Arial"/>
                  <a:ea typeface="Arial"/>
                  <a:cs typeface="Arial"/>
                  <a:sym typeface="Arial"/>
                </a:defRPr>
              </a:pPr>
              <a:endParaRPr sz="1266"/>
            </a:p>
          </p:txBody>
        </p:sp>
        <p:sp>
          <p:nvSpPr>
            <p:cNvPr id="25" name="Shape 270"/>
            <p:cNvSpPr/>
            <p:nvPr/>
          </p:nvSpPr>
          <p:spPr>
            <a:xfrm rot="16200000">
              <a:off x="7875347" y="2524111"/>
              <a:ext cx="404709" cy="1413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ctr">
              <a:noAutofit/>
            </a:bodyPr>
            <a:lstStyle>
              <a:lvl1pPr defTabSz="914400">
                <a:defRPr sz="12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>
                <a:defRPr sz="1800"/>
              </a:pPr>
              <a:r>
                <a:rPr sz="844" dirty="0"/>
                <a:t>IFN-γ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9182957" y="2179314"/>
              <a:ext cx="841120" cy="976036"/>
              <a:chOff x="7736600" y="3566748"/>
              <a:chExt cx="841120" cy="976036"/>
            </a:xfrm>
          </p:grpSpPr>
          <p:pic>
            <p:nvPicPr>
              <p:cNvPr id="22" name="image20.tif"/>
              <p:cNvPicPr>
                <a:picLocks noChangeAspect="1"/>
              </p:cNvPicPr>
              <p:nvPr/>
            </p:nvPicPr>
            <p:blipFill>
              <a:blip r:embed="rId2">
                <a:extLst/>
              </a:blip>
              <a:stretch>
                <a:fillRect/>
              </a:stretch>
            </p:blipFill>
            <p:spPr>
              <a:xfrm>
                <a:off x="7736600" y="3566748"/>
                <a:ext cx="841120" cy="97603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42" name="Shape 277"/>
              <p:cNvSpPr/>
              <p:nvPr/>
            </p:nvSpPr>
            <p:spPr>
              <a:xfrm>
                <a:off x="8397824" y="3618394"/>
                <a:ext cx="148884" cy="80276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algn="r" defTabSz="642915"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40" name="Shape 280"/>
              <p:cNvSpPr/>
              <p:nvPr/>
            </p:nvSpPr>
            <p:spPr>
              <a:xfrm>
                <a:off x="8310211" y="4424765"/>
                <a:ext cx="239242" cy="72429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algn="r" defTabSz="642915"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38" name="Shape 283"/>
              <p:cNvSpPr/>
              <p:nvPr/>
            </p:nvSpPr>
            <p:spPr>
              <a:xfrm>
                <a:off x="7780342" y="4420163"/>
                <a:ext cx="228802" cy="72429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defTabSz="642915"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36" name="Shape 286"/>
              <p:cNvSpPr/>
              <p:nvPr/>
            </p:nvSpPr>
            <p:spPr>
              <a:xfrm>
                <a:off x="7775631" y="3615076"/>
                <a:ext cx="227890" cy="78992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defTabSz="642915"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</p:grpSp>
        <p:sp>
          <p:nvSpPr>
            <p:cNvPr id="89" name="Shape 295"/>
            <p:cNvSpPr/>
            <p:nvPr/>
          </p:nvSpPr>
          <p:spPr>
            <a:xfrm>
              <a:off x="8383687" y="4454360"/>
              <a:ext cx="471626" cy="14129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t">
              <a:noAutofit/>
            </a:bodyPr>
            <a:lstStyle>
              <a:lvl1pPr defTabSz="914400">
                <a:defRPr sz="12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>
                <a:defRPr sz="1800"/>
              </a:pPr>
              <a:r>
                <a:rPr sz="844"/>
                <a:t>CD107a</a:t>
              </a:r>
            </a:p>
          </p:txBody>
        </p:sp>
        <p:sp>
          <p:nvSpPr>
            <p:cNvPr id="56" name="Shape 297"/>
            <p:cNvSpPr/>
            <p:nvPr/>
          </p:nvSpPr>
          <p:spPr>
            <a:xfrm rot="16200000">
              <a:off x="7884104" y="3832733"/>
              <a:ext cx="387180" cy="14129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ctr">
              <a:noAutofit/>
            </a:bodyPr>
            <a:lstStyle>
              <a:lvl1pPr defTabSz="914400">
                <a:defRPr sz="12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>
                <a:defRPr sz="1800"/>
              </a:pPr>
              <a:r>
                <a:rPr sz="844" dirty="0"/>
                <a:t>IFN-γ</a:t>
              </a:r>
            </a:p>
          </p:txBody>
        </p:sp>
        <p:sp>
          <p:nvSpPr>
            <p:cNvPr id="87" name="Shape 300"/>
            <p:cNvSpPr/>
            <p:nvPr/>
          </p:nvSpPr>
          <p:spPr>
            <a:xfrm>
              <a:off x="9458508" y="4454668"/>
              <a:ext cx="394876" cy="1412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t">
              <a:noAutofit/>
            </a:bodyPr>
            <a:lstStyle>
              <a:lvl1pPr defTabSz="914400">
                <a:defRPr sz="12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>
                <a:defRPr sz="1800"/>
              </a:pPr>
              <a:r>
                <a:rPr sz="844"/>
                <a:t>CCL4</a:t>
              </a:r>
            </a:p>
          </p:txBody>
        </p:sp>
        <p:sp>
          <p:nvSpPr>
            <p:cNvPr id="60" name="Shape 303"/>
            <p:cNvSpPr/>
            <p:nvPr/>
          </p:nvSpPr>
          <p:spPr>
            <a:xfrm rot="16200000">
              <a:off x="8876508" y="3797785"/>
              <a:ext cx="457077" cy="14129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ctr">
              <a:noAutofit/>
            </a:bodyPr>
            <a:lstStyle>
              <a:lvl1pPr defTabSz="914400">
                <a:defRPr sz="12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>
                <a:defRPr sz="1800"/>
              </a:pPr>
              <a:r>
                <a:rPr sz="844"/>
                <a:t>IFN-γ</a:t>
              </a:r>
            </a:p>
          </p:txBody>
        </p:sp>
        <p:sp>
          <p:nvSpPr>
            <p:cNvPr id="61" name="Shape 304"/>
            <p:cNvSpPr/>
            <p:nvPr/>
          </p:nvSpPr>
          <p:spPr>
            <a:xfrm>
              <a:off x="7829366" y="3470330"/>
              <a:ext cx="286922" cy="14129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0" tIns="0" rIns="0" bIns="0" numCol="1" anchor="ctr">
              <a:noAutofit/>
            </a:bodyPr>
            <a:lstStyle/>
            <a:p>
              <a:pPr defTabSz="642915">
                <a:defRPr sz="1800">
                  <a:latin typeface="Arial"/>
                  <a:ea typeface="Arial"/>
                  <a:cs typeface="Arial"/>
                  <a:sym typeface="Arial"/>
                </a:defRPr>
              </a:pPr>
              <a:r>
                <a:rPr sz="844" b="1"/>
                <a:t>IgG</a:t>
              </a:r>
              <a:r>
                <a:rPr sz="844" b="1" baseline="31999"/>
                <a:t>+</a:t>
              </a: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9183033" y="3470009"/>
              <a:ext cx="841045" cy="975949"/>
              <a:chOff x="7758780" y="4857442"/>
              <a:chExt cx="841045" cy="975949"/>
            </a:xfrm>
          </p:grpSpPr>
          <p:pic>
            <p:nvPicPr>
              <p:cNvPr id="59" name="image18.tif"/>
              <p:cNvPicPr>
                <a:picLocks noChangeAspect="1"/>
              </p:cNvPicPr>
              <p:nvPr/>
            </p:nvPicPr>
            <p:blipFill>
              <a:blip r:embed="rId3">
                <a:extLst/>
              </a:blip>
              <a:stretch>
                <a:fillRect/>
              </a:stretch>
            </p:blipFill>
            <p:spPr>
              <a:xfrm>
                <a:off x="7758780" y="4857442"/>
                <a:ext cx="841045" cy="975949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80" name="Shape 311"/>
              <p:cNvSpPr/>
              <p:nvPr/>
            </p:nvSpPr>
            <p:spPr>
              <a:xfrm>
                <a:off x="8381340" y="4918502"/>
                <a:ext cx="178021" cy="66013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algn="r" defTabSz="642915">
                  <a:lnSpc>
                    <a:spcPct val="80000"/>
                  </a:lnSpc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78" name="Shape 314"/>
              <p:cNvSpPr/>
              <p:nvPr/>
            </p:nvSpPr>
            <p:spPr>
              <a:xfrm>
                <a:off x="8295284" y="5721838"/>
                <a:ext cx="263524" cy="66230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ctr">
                <a:noAutofit/>
              </a:bodyPr>
              <a:lstStyle/>
              <a:p>
                <a:pPr algn="r" defTabSz="642915">
                  <a:lnSpc>
                    <a:spcPct val="80000"/>
                  </a:lnSpc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76" name="Shape 317"/>
              <p:cNvSpPr/>
              <p:nvPr/>
            </p:nvSpPr>
            <p:spPr>
              <a:xfrm>
                <a:off x="7796760" y="4900094"/>
                <a:ext cx="203490" cy="69817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ctr">
                <a:noAutofit/>
              </a:bodyPr>
              <a:lstStyle/>
              <a:p>
                <a:pPr defTabSz="642915">
                  <a:lnSpc>
                    <a:spcPct val="80000"/>
                  </a:lnSpc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74" name="Shape 320"/>
              <p:cNvSpPr/>
              <p:nvPr/>
            </p:nvSpPr>
            <p:spPr>
              <a:xfrm>
                <a:off x="7789279" y="5721956"/>
                <a:ext cx="131967" cy="66111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ctr">
                <a:noAutofit/>
              </a:bodyPr>
              <a:lstStyle/>
              <a:p>
                <a:pPr defTabSz="642915">
                  <a:lnSpc>
                    <a:spcPct val="80000"/>
                  </a:lnSpc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8149784" y="3470330"/>
              <a:ext cx="841045" cy="975949"/>
              <a:chOff x="6705948" y="4857763"/>
              <a:chExt cx="841045" cy="975949"/>
            </a:xfrm>
          </p:grpSpPr>
          <p:pic>
            <p:nvPicPr>
              <p:cNvPr id="57" name="image17.tif"/>
              <p:cNvPicPr>
                <a:picLocks noChangeAspect="1"/>
              </p:cNvPicPr>
              <p:nvPr/>
            </p:nvPicPr>
            <p:blipFill>
              <a:blip r:embed="rId4">
                <a:extLst/>
              </a:blip>
              <a:stretch>
                <a:fillRect/>
              </a:stretch>
            </p:blipFill>
            <p:spPr>
              <a:xfrm>
                <a:off x="6705948" y="4857763"/>
                <a:ext cx="841045" cy="975949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84" name="Shape 305"/>
              <p:cNvSpPr/>
              <p:nvPr/>
            </p:nvSpPr>
            <p:spPr>
              <a:xfrm>
                <a:off x="7293573" y="4900094"/>
                <a:ext cx="219761" cy="69817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algn="r" defTabSz="642915">
                  <a:lnSpc>
                    <a:spcPct val="80000"/>
                  </a:lnSpc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82" name="Shape 308"/>
              <p:cNvSpPr/>
              <p:nvPr/>
            </p:nvSpPr>
            <p:spPr>
              <a:xfrm>
                <a:off x="7293349" y="5721957"/>
                <a:ext cx="219761" cy="66111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b">
                <a:noAutofit/>
              </a:bodyPr>
              <a:lstStyle/>
              <a:p>
                <a:pPr algn="r" defTabSz="642915">
                  <a:lnSpc>
                    <a:spcPct val="80000"/>
                  </a:lnSpc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72" name="Shape 323"/>
              <p:cNvSpPr/>
              <p:nvPr/>
            </p:nvSpPr>
            <p:spPr>
              <a:xfrm>
                <a:off x="6743851" y="5736189"/>
                <a:ext cx="236608" cy="51879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defTabSz="642915">
                  <a:lnSpc>
                    <a:spcPct val="80000"/>
                  </a:lnSpc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70" name="Shape 326"/>
              <p:cNvSpPr/>
              <p:nvPr/>
            </p:nvSpPr>
            <p:spPr>
              <a:xfrm>
                <a:off x="6746468" y="4900094"/>
                <a:ext cx="236608" cy="66158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b">
                <a:noAutofit/>
              </a:bodyPr>
              <a:lstStyle/>
              <a:p>
                <a:pPr defTabSz="642915">
                  <a:lnSpc>
                    <a:spcPct val="80000"/>
                  </a:lnSpc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</p:grpSp>
        <p:sp>
          <p:nvSpPr>
            <p:cNvPr id="90" name="Shape 330"/>
            <p:cNvSpPr/>
            <p:nvPr/>
          </p:nvSpPr>
          <p:spPr>
            <a:xfrm>
              <a:off x="7859266" y="1967007"/>
              <a:ext cx="126638" cy="151452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0" tIns="0" rIns="0" bIns="0" anchor="ctr">
              <a:spAutoFit/>
            </a:bodyPr>
            <a:lstStyle>
              <a:lvl1pPr>
                <a:defRPr sz="1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rPr sz="984" dirty="0"/>
                <a:t>B.</a:t>
              </a: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8149784" y="2180016"/>
              <a:ext cx="841119" cy="976036"/>
              <a:chOff x="6703426" y="3567450"/>
              <a:chExt cx="841119" cy="976036"/>
            </a:xfrm>
          </p:grpSpPr>
          <p:pic>
            <p:nvPicPr>
              <p:cNvPr id="19" name="image19.tif"/>
              <p:cNvPicPr>
                <a:picLocks noChangeAspect="1"/>
              </p:cNvPicPr>
              <p:nvPr/>
            </p:nvPicPr>
            <p:blipFill>
              <a:blip r:embed="rId5">
                <a:extLst/>
              </a:blip>
              <a:stretch>
                <a:fillRect/>
              </a:stretch>
            </p:blipFill>
            <p:spPr>
              <a:xfrm>
                <a:off x="6703426" y="3567450"/>
                <a:ext cx="841119" cy="97603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46" name="Shape 271"/>
              <p:cNvSpPr/>
              <p:nvPr/>
            </p:nvSpPr>
            <p:spPr>
              <a:xfrm>
                <a:off x="7358645" y="3609969"/>
                <a:ext cx="148884" cy="51885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algn="r" defTabSz="642915"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44" name="Shape 274"/>
              <p:cNvSpPr/>
              <p:nvPr/>
            </p:nvSpPr>
            <p:spPr>
              <a:xfrm>
                <a:off x="7362751" y="4431504"/>
                <a:ext cx="148885" cy="51884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algn="r" defTabSz="642915"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34" name="Shape 289"/>
              <p:cNvSpPr/>
              <p:nvPr/>
            </p:nvSpPr>
            <p:spPr>
              <a:xfrm>
                <a:off x="6741345" y="3604593"/>
                <a:ext cx="193039" cy="71067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defTabSz="642915"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  <p:sp>
            <p:nvSpPr>
              <p:cNvPr id="120" name="Shape 274"/>
              <p:cNvSpPr/>
              <p:nvPr/>
            </p:nvSpPr>
            <p:spPr>
              <a:xfrm>
                <a:off x="6737608" y="4425551"/>
                <a:ext cx="148885" cy="51884"/>
              </a:xfrm>
              <a:prstGeom prst="rect">
                <a:avLst/>
              </a:pr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32145" tIns="32145" rIns="32145" bIns="32145" numCol="1" anchor="t">
                <a:noAutofit/>
              </a:bodyPr>
              <a:lstStyle/>
              <a:p>
                <a:pPr algn="r" defTabSz="642915">
                  <a:defRPr sz="1800" b="1">
                    <a:latin typeface="Arial"/>
                    <a:ea typeface="Arial"/>
                    <a:cs typeface="Arial"/>
                    <a:sym typeface="Arial"/>
                  </a:defRPr>
                </a:pPr>
                <a:endParaRPr sz="600"/>
              </a:p>
            </p:txBody>
          </p:sp>
        </p:grpSp>
      </p:grpSp>
      <p:sp>
        <p:nvSpPr>
          <p:cNvPr id="77" name="Shape 318"/>
          <p:cNvSpPr/>
          <p:nvPr/>
        </p:nvSpPr>
        <p:spPr>
          <a:xfrm>
            <a:off x="9244993" y="3508058"/>
            <a:ext cx="203490" cy="9751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ctr">
            <a:noAutofit/>
          </a:bodyPr>
          <a:lstStyle>
            <a:lvl1pPr algn="l" defTabSz="914400">
              <a:lnSpc>
                <a:spcPct val="80000"/>
              </a:lnSpc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7.97</a:t>
            </a:r>
          </a:p>
        </p:txBody>
      </p:sp>
      <p:sp>
        <p:nvSpPr>
          <p:cNvPr id="71" name="Shape 327"/>
          <p:cNvSpPr/>
          <p:nvPr/>
        </p:nvSpPr>
        <p:spPr>
          <a:xfrm>
            <a:off x="8204350" y="3508058"/>
            <a:ext cx="236608" cy="9751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b">
            <a:noAutofit/>
          </a:bodyPr>
          <a:lstStyle>
            <a:lvl1pPr algn="l" defTabSz="914400">
              <a:lnSpc>
                <a:spcPct val="80000"/>
              </a:lnSpc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7.04</a:t>
            </a:r>
          </a:p>
        </p:txBody>
      </p:sp>
      <p:sp>
        <p:nvSpPr>
          <p:cNvPr id="73" name="Shape 324"/>
          <p:cNvSpPr/>
          <p:nvPr/>
        </p:nvSpPr>
        <p:spPr>
          <a:xfrm>
            <a:off x="8204350" y="4314310"/>
            <a:ext cx="236608" cy="9751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l" defTabSz="914400">
              <a:lnSpc>
                <a:spcPct val="80000"/>
              </a:lnSpc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62.1</a:t>
            </a:r>
          </a:p>
        </p:txBody>
      </p:sp>
      <p:sp>
        <p:nvSpPr>
          <p:cNvPr id="121" name="Shape 324"/>
          <p:cNvSpPr/>
          <p:nvPr/>
        </p:nvSpPr>
        <p:spPr>
          <a:xfrm>
            <a:off x="9244993" y="4314310"/>
            <a:ext cx="236608" cy="9751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l" defTabSz="914400">
              <a:lnSpc>
                <a:spcPct val="80000"/>
              </a:lnSpc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lang="en-CA" sz="600" dirty="0"/>
              <a:t>69.6</a:t>
            </a:r>
            <a:endParaRPr sz="600" dirty="0"/>
          </a:p>
        </p:txBody>
      </p:sp>
      <p:sp>
        <p:nvSpPr>
          <p:cNvPr id="47" name="Shape 272"/>
          <p:cNvSpPr/>
          <p:nvPr/>
        </p:nvSpPr>
        <p:spPr>
          <a:xfrm>
            <a:off x="8787578" y="2222920"/>
            <a:ext cx="148884" cy="97520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r" defTabSz="914400"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0.07</a:t>
            </a:r>
          </a:p>
        </p:txBody>
      </p:sp>
      <p:sp>
        <p:nvSpPr>
          <p:cNvPr id="43" name="Shape 278"/>
          <p:cNvSpPr/>
          <p:nvPr/>
        </p:nvSpPr>
        <p:spPr>
          <a:xfrm>
            <a:off x="9824074" y="2222920"/>
            <a:ext cx="148884" cy="9752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r" defTabSz="914400"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0.4</a:t>
            </a:r>
          </a:p>
        </p:txBody>
      </p:sp>
      <p:sp>
        <p:nvSpPr>
          <p:cNvPr id="37" name="Shape 287"/>
          <p:cNvSpPr/>
          <p:nvPr/>
        </p:nvSpPr>
        <p:spPr>
          <a:xfrm>
            <a:off x="9244993" y="2222920"/>
            <a:ext cx="227890" cy="9752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l" defTabSz="914400"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2.66</a:t>
            </a:r>
          </a:p>
        </p:txBody>
      </p:sp>
      <p:sp>
        <p:nvSpPr>
          <p:cNvPr id="35" name="Shape 290"/>
          <p:cNvSpPr/>
          <p:nvPr/>
        </p:nvSpPr>
        <p:spPr>
          <a:xfrm>
            <a:off x="8204351" y="2222920"/>
            <a:ext cx="193039" cy="9752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l" defTabSz="914400"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2.75</a:t>
            </a:r>
          </a:p>
        </p:txBody>
      </p:sp>
      <p:sp>
        <p:nvSpPr>
          <p:cNvPr id="45" name="Shape 275"/>
          <p:cNvSpPr/>
          <p:nvPr/>
        </p:nvSpPr>
        <p:spPr>
          <a:xfrm>
            <a:off x="8787578" y="3007638"/>
            <a:ext cx="148885" cy="9752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r" defTabSz="914400"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1.25</a:t>
            </a:r>
          </a:p>
        </p:txBody>
      </p:sp>
      <p:sp>
        <p:nvSpPr>
          <p:cNvPr id="41" name="Shape 281"/>
          <p:cNvSpPr/>
          <p:nvPr/>
        </p:nvSpPr>
        <p:spPr>
          <a:xfrm>
            <a:off x="9733716" y="3007638"/>
            <a:ext cx="239242" cy="9752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r" defTabSz="914400"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2.11</a:t>
            </a:r>
          </a:p>
        </p:txBody>
      </p:sp>
      <p:sp>
        <p:nvSpPr>
          <p:cNvPr id="39" name="Shape 284"/>
          <p:cNvSpPr/>
          <p:nvPr/>
        </p:nvSpPr>
        <p:spPr>
          <a:xfrm>
            <a:off x="9244993" y="3007638"/>
            <a:ext cx="228802" cy="9752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l" defTabSz="914400"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94.8</a:t>
            </a:r>
          </a:p>
        </p:txBody>
      </p:sp>
      <p:sp>
        <p:nvSpPr>
          <p:cNvPr id="33" name="Shape 292"/>
          <p:cNvSpPr/>
          <p:nvPr/>
        </p:nvSpPr>
        <p:spPr>
          <a:xfrm>
            <a:off x="8204351" y="3007640"/>
            <a:ext cx="193039" cy="97519"/>
          </a:xfrm>
          <a:prstGeom prst="rect">
            <a:avLst/>
          </a:prstGeom>
          <a:solidFill>
            <a:srgbClr val="FFFFFF"/>
          </a:solidFill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ctr">
            <a:noAutofit/>
          </a:bodyPr>
          <a:lstStyle>
            <a:lvl1pPr algn="l" defTabSz="914400"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sz="600" dirty="0"/>
              <a:t>95.6</a:t>
            </a:r>
          </a:p>
        </p:txBody>
      </p:sp>
      <p:sp>
        <p:nvSpPr>
          <p:cNvPr id="122" name="Shape 324"/>
          <p:cNvSpPr/>
          <p:nvPr/>
        </p:nvSpPr>
        <p:spPr>
          <a:xfrm>
            <a:off x="8699854" y="4314310"/>
            <a:ext cx="236608" cy="9751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l" defTabSz="914400">
              <a:lnSpc>
                <a:spcPct val="80000"/>
              </a:lnSpc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algn="r"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lang="en-CA" sz="600" dirty="0"/>
              <a:t>19.3</a:t>
            </a:r>
            <a:endParaRPr sz="600" dirty="0"/>
          </a:p>
        </p:txBody>
      </p:sp>
      <p:sp>
        <p:nvSpPr>
          <p:cNvPr id="123" name="Shape 324"/>
          <p:cNvSpPr/>
          <p:nvPr/>
        </p:nvSpPr>
        <p:spPr>
          <a:xfrm>
            <a:off x="9736350" y="4314310"/>
            <a:ext cx="236608" cy="9751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t">
            <a:noAutofit/>
          </a:bodyPr>
          <a:lstStyle>
            <a:lvl1pPr algn="l" defTabSz="914400">
              <a:lnSpc>
                <a:spcPct val="80000"/>
              </a:lnSpc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algn="r"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lang="en-CA" sz="600" dirty="0"/>
              <a:t>11.4</a:t>
            </a:r>
            <a:endParaRPr sz="600" dirty="0"/>
          </a:p>
        </p:txBody>
      </p:sp>
      <p:sp>
        <p:nvSpPr>
          <p:cNvPr id="124" name="Shape 327"/>
          <p:cNvSpPr/>
          <p:nvPr/>
        </p:nvSpPr>
        <p:spPr>
          <a:xfrm>
            <a:off x="8699854" y="3508058"/>
            <a:ext cx="236608" cy="9751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b">
            <a:noAutofit/>
          </a:bodyPr>
          <a:lstStyle>
            <a:lvl1pPr algn="l" defTabSz="914400">
              <a:lnSpc>
                <a:spcPct val="80000"/>
              </a:lnSpc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algn="r"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lang="en-CA" sz="600" dirty="0"/>
              <a:t>11.6</a:t>
            </a:r>
            <a:endParaRPr sz="600" dirty="0"/>
          </a:p>
        </p:txBody>
      </p:sp>
      <p:sp>
        <p:nvSpPr>
          <p:cNvPr id="125" name="Shape 327"/>
          <p:cNvSpPr/>
          <p:nvPr/>
        </p:nvSpPr>
        <p:spPr>
          <a:xfrm>
            <a:off x="9736350" y="3508058"/>
            <a:ext cx="236608" cy="9751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0" tIns="0" rIns="0" bIns="0" numCol="1" anchor="b">
            <a:noAutofit/>
          </a:bodyPr>
          <a:lstStyle>
            <a:lvl1pPr algn="l" defTabSz="914400">
              <a:lnSpc>
                <a:spcPct val="80000"/>
              </a:lnSpc>
              <a:defRPr sz="7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algn="r">
              <a:defRPr sz="1800" b="1">
                <a:latin typeface="Arial"/>
                <a:ea typeface="Arial"/>
                <a:cs typeface="Arial"/>
                <a:sym typeface="Arial"/>
              </a:defRPr>
            </a:pPr>
            <a:r>
              <a:rPr lang="en-CA" sz="600" dirty="0"/>
              <a:t>11.1</a:t>
            </a:r>
            <a:endParaRPr sz="600" dirty="0"/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3BBC9158-92F2-4414-A407-AF4826FB2F25}"/>
              </a:ext>
            </a:extLst>
          </p:cNvPr>
          <p:cNvGrpSpPr/>
          <p:nvPr/>
        </p:nvGrpSpPr>
        <p:grpSpPr>
          <a:xfrm>
            <a:off x="2240288" y="1631180"/>
            <a:ext cx="5168551" cy="2947955"/>
            <a:chOff x="701435" y="2193564"/>
            <a:chExt cx="4704213" cy="2416981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E558892F-4D68-4138-A9F6-69A99F8161CC}"/>
                </a:ext>
              </a:extLst>
            </p:cNvPr>
            <p:cNvGrpSpPr/>
            <p:nvPr/>
          </p:nvGrpSpPr>
          <p:grpSpPr>
            <a:xfrm>
              <a:off x="4354214" y="3560201"/>
              <a:ext cx="1051434" cy="1050344"/>
              <a:chOff x="4354214" y="3560201"/>
              <a:chExt cx="1051434" cy="1050344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490105" y="3560201"/>
                <a:ext cx="915543" cy="915543"/>
              </a:xfrm>
              <a:prstGeom prst="rect">
                <a:avLst/>
              </a:prstGeom>
            </p:spPr>
          </p:pic>
          <p:sp>
            <p:nvSpPr>
              <p:cNvPr id="98" name="Shape 337"/>
              <p:cNvSpPr/>
              <p:nvPr/>
            </p:nvSpPr>
            <p:spPr>
              <a:xfrm>
                <a:off x="4770882" y="4500889"/>
                <a:ext cx="422612" cy="10965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>
                <a:lvl1pPr defTabSz="914400"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/>
                  <a:t>NKG2A</a:t>
                </a:r>
              </a:p>
            </p:txBody>
          </p:sp>
          <p:sp>
            <p:nvSpPr>
              <p:cNvPr id="99" name="Shape 338"/>
              <p:cNvSpPr/>
              <p:nvPr/>
            </p:nvSpPr>
            <p:spPr>
              <a:xfrm rot="16200000">
                <a:off x="4221052" y="3908339"/>
                <a:ext cx="375980" cy="10965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b">
                <a:noAutofit/>
              </a:bodyPr>
              <a:lstStyle>
                <a:lvl1pPr algn="l" defTabSz="914400">
                  <a:lnSpc>
                    <a:spcPct val="120000"/>
                  </a:lnSpc>
                  <a:spcBef>
                    <a:spcPts val="1200"/>
                  </a:spcBef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/>
                  <a:t>SSC-A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DFB315D1-4894-4C2D-B08D-0ECEAF1011B2}"/>
                </a:ext>
              </a:extLst>
            </p:cNvPr>
            <p:cNvGrpSpPr/>
            <p:nvPr/>
          </p:nvGrpSpPr>
          <p:grpSpPr>
            <a:xfrm>
              <a:off x="1919047" y="3560201"/>
              <a:ext cx="2275271" cy="1050344"/>
              <a:chOff x="1919047" y="3560201"/>
              <a:chExt cx="2275271" cy="1050344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278775" y="3560201"/>
                <a:ext cx="915543" cy="915543"/>
              </a:xfrm>
              <a:prstGeom prst="rect">
                <a:avLst/>
              </a:prstGeom>
            </p:spPr>
          </p:pic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C82F3116-C1CB-4B3A-95BB-350024189E2A}"/>
                  </a:ext>
                </a:extLst>
              </p:cNvPr>
              <p:cNvGrpSpPr/>
              <p:nvPr/>
            </p:nvGrpSpPr>
            <p:grpSpPr>
              <a:xfrm>
                <a:off x="1919047" y="3560201"/>
                <a:ext cx="1063941" cy="1050344"/>
                <a:chOff x="1919047" y="3560201"/>
                <a:chExt cx="1063941" cy="1050344"/>
              </a:xfrm>
            </p:grpSpPr>
            <p:pic>
              <p:nvPicPr>
                <p:cNvPr id="15" name="Picture 14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2067445" y="3560201"/>
                  <a:ext cx="915543" cy="915543"/>
                </a:xfrm>
                <a:prstGeom prst="rect">
                  <a:avLst/>
                </a:prstGeom>
              </p:spPr>
            </p:pic>
            <p:sp>
              <p:nvSpPr>
                <p:cNvPr id="94" name="Shape 334"/>
                <p:cNvSpPr/>
                <p:nvPr/>
              </p:nvSpPr>
              <p:spPr>
                <a:xfrm>
                  <a:off x="2353564" y="4500889"/>
                  <a:ext cx="342280" cy="10965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 val="1"/>
                  </a:ext>
                </a:extLst>
              </p:spPr>
              <p:txBody>
                <a:bodyPr wrap="square" lIns="0" tIns="0" rIns="0" bIns="0" numCol="1" anchor="ctr">
                  <a:noAutofit/>
                </a:bodyPr>
                <a:lstStyle>
                  <a:lvl1pPr defTabSz="914400">
                    <a:defRPr sz="1200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pPr>
                    <a:defRPr sz="1800" b="1"/>
                  </a:pPr>
                  <a:r>
                    <a:rPr sz="844"/>
                    <a:t>2DL3</a:t>
                  </a:r>
                </a:p>
              </p:txBody>
            </p:sp>
            <p:sp>
              <p:nvSpPr>
                <p:cNvPr id="95" name="Shape 335"/>
                <p:cNvSpPr/>
                <p:nvPr/>
              </p:nvSpPr>
              <p:spPr>
                <a:xfrm rot="16200000">
                  <a:off x="1755564" y="3978843"/>
                  <a:ext cx="436623" cy="109657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 val="1"/>
                  </a:ext>
                </a:extLst>
              </p:spPr>
              <p:txBody>
                <a:bodyPr wrap="square" lIns="0" tIns="0" rIns="0" bIns="0" numCol="1" anchor="ctr">
                  <a:noAutofit/>
                </a:bodyPr>
                <a:lstStyle>
                  <a:lvl1pPr defTabSz="914400">
                    <a:defRPr sz="1200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pPr>
                    <a:defRPr sz="1800"/>
                  </a:pPr>
                  <a:r>
                    <a:rPr sz="844" b="1" dirty="0"/>
                    <a:t>2DL/S2</a:t>
                  </a:r>
                </a:p>
              </p:txBody>
            </p:sp>
          </p:grpSp>
          <p:sp>
            <p:nvSpPr>
              <p:cNvPr id="102" name="Shape 341"/>
              <p:cNvSpPr/>
              <p:nvPr/>
            </p:nvSpPr>
            <p:spPr>
              <a:xfrm>
                <a:off x="3594214" y="4500888"/>
                <a:ext cx="342281" cy="1096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>
                <a:lvl1pPr defTabSz="914400"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/>
                  <a:t>3DL1</a:t>
                </a:r>
              </a:p>
            </p:txBody>
          </p:sp>
          <p:sp>
            <p:nvSpPr>
              <p:cNvPr id="103" name="Shape 342"/>
              <p:cNvSpPr/>
              <p:nvPr/>
            </p:nvSpPr>
            <p:spPr>
              <a:xfrm rot="16200000">
                <a:off x="2982990" y="3942773"/>
                <a:ext cx="376450" cy="10979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b">
                <a:noAutofit/>
              </a:bodyPr>
              <a:lstStyle>
                <a:lvl1pPr algn="l" defTabSz="914400">
                  <a:lnSpc>
                    <a:spcPct val="120000"/>
                  </a:lnSpc>
                  <a:spcBef>
                    <a:spcPts val="1200"/>
                  </a:spcBef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/>
                  <a:t>SSC-A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893F2A85-05C1-4A78-B38A-F1AE43EF94FB}"/>
                </a:ext>
              </a:extLst>
            </p:cNvPr>
            <p:cNvGrpSpPr/>
            <p:nvPr/>
          </p:nvGrpSpPr>
          <p:grpSpPr>
            <a:xfrm>
              <a:off x="701435" y="3560201"/>
              <a:ext cx="1070223" cy="1050344"/>
              <a:chOff x="701435" y="3560201"/>
              <a:chExt cx="1070223" cy="1050344"/>
            </a:xfrm>
          </p:grpSpPr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56115" y="3560201"/>
                <a:ext cx="915543" cy="915543"/>
              </a:xfrm>
              <a:prstGeom prst="rect">
                <a:avLst/>
              </a:prstGeom>
            </p:spPr>
          </p:pic>
          <p:sp>
            <p:nvSpPr>
              <p:cNvPr id="116" name="Shape 355"/>
              <p:cNvSpPr/>
              <p:nvPr/>
            </p:nvSpPr>
            <p:spPr>
              <a:xfrm>
                <a:off x="1149480" y="4500888"/>
                <a:ext cx="342281" cy="1096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>
                <a:lvl1pPr defTabSz="914400"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 dirty="0"/>
                  <a:t>2DL1</a:t>
                </a:r>
              </a:p>
            </p:txBody>
          </p:sp>
          <p:sp>
            <p:nvSpPr>
              <p:cNvPr id="117" name="Shape 356"/>
              <p:cNvSpPr/>
              <p:nvPr/>
            </p:nvSpPr>
            <p:spPr>
              <a:xfrm rot="16200000">
                <a:off x="568274" y="3957557"/>
                <a:ext cx="375980" cy="1096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b">
                <a:noAutofit/>
              </a:bodyPr>
              <a:lstStyle>
                <a:lvl1pPr algn="l" defTabSz="914400">
                  <a:lnSpc>
                    <a:spcPct val="120000"/>
                  </a:lnSpc>
                  <a:spcBef>
                    <a:spcPts val="1200"/>
                  </a:spcBef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 dirty="0"/>
                  <a:t>SSC-A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F5E2263D-17E5-4F4E-9A03-840A57C254FA}"/>
                </a:ext>
              </a:extLst>
            </p:cNvPr>
            <p:cNvGrpSpPr/>
            <p:nvPr/>
          </p:nvGrpSpPr>
          <p:grpSpPr>
            <a:xfrm>
              <a:off x="701435" y="2193564"/>
              <a:ext cx="1298093" cy="1064249"/>
              <a:chOff x="701435" y="2193564"/>
              <a:chExt cx="1298093" cy="1064249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856115" y="2193564"/>
                <a:ext cx="915543" cy="915543"/>
              </a:xfrm>
              <a:prstGeom prst="rect">
                <a:avLst/>
              </a:prstGeom>
            </p:spPr>
          </p:pic>
          <p:sp>
            <p:nvSpPr>
              <p:cNvPr id="111" name="Shape 350"/>
              <p:cNvSpPr/>
              <p:nvPr/>
            </p:nvSpPr>
            <p:spPr>
              <a:xfrm>
                <a:off x="1109288" y="3147256"/>
                <a:ext cx="422664" cy="1105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>
                <a:lvl1pPr defTabSz="914400"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/>
                  <a:t>FSC-A</a:t>
                </a:r>
              </a:p>
            </p:txBody>
          </p:sp>
          <p:sp>
            <p:nvSpPr>
              <p:cNvPr id="112" name="Shape 351"/>
              <p:cNvSpPr/>
              <p:nvPr/>
            </p:nvSpPr>
            <p:spPr>
              <a:xfrm rot="16200000">
                <a:off x="567180" y="2536027"/>
                <a:ext cx="379068" cy="1105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b">
                <a:noAutofit/>
              </a:bodyPr>
              <a:lstStyle>
                <a:lvl1pPr algn="l" defTabSz="914400">
                  <a:lnSpc>
                    <a:spcPct val="120000"/>
                  </a:lnSpc>
                  <a:spcBef>
                    <a:spcPts val="1200"/>
                  </a:spcBef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 dirty="0"/>
                  <a:t>SSC-A</a:t>
                </a:r>
              </a:p>
            </p:txBody>
          </p:sp>
          <p:cxnSp>
            <p:nvCxnSpPr>
              <p:cNvPr id="127" name="Straight Arrow Connector 126"/>
              <p:cNvCxnSpPr/>
              <p:nvPr/>
            </p:nvCxnSpPr>
            <p:spPr>
              <a:xfrm>
                <a:off x="1204267" y="3022438"/>
                <a:ext cx="79526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542B11C0-2BDA-4EC5-99E4-1C189EE3E421}"/>
                </a:ext>
              </a:extLst>
            </p:cNvPr>
            <p:cNvGrpSpPr/>
            <p:nvPr/>
          </p:nvGrpSpPr>
          <p:grpSpPr>
            <a:xfrm>
              <a:off x="1919047" y="2193564"/>
              <a:ext cx="1305149" cy="1064249"/>
              <a:chOff x="1919047" y="2193564"/>
              <a:chExt cx="1305149" cy="1064249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067445" y="2193564"/>
                <a:ext cx="915543" cy="915543"/>
              </a:xfrm>
              <a:prstGeom prst="rect">
                <a:avLst/>
              </a:prstGeom>
            </p:spPr>
          </p:pic>
          <p:sp>
            <p:nvSpPr>
              <p:cNvPr id="104" name="Shape 344"/>
              <p:cNvSpPr/>
              <p:nvPr/>
            </p:nvSpPr>
            <p:spPr>
              <a:xfrm>
                <a:off x="2341942" y="3147256"/>
                <a:ext cx="365524" cy="1105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t">
                <a:noAutofit/>
              </a:bodyPr>
              <a:lstStyle>
                <a:lvl1pPr defTabSz="914400"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 dirty="0"/>
                  <a:t>FSC-A</a:t>
                </a:r>
              </a:p>
            </p:txBody>
          </p:sp>
          <p:sp>
            <p:nvSpPr>
              <p:cNvPr id="105" name="Shape 345"/>
              <p:cNvSpPr/>
              <p:nvPr/>
            </p:nvSpPr>
            <p:spPr>
              <a:xfrm rot="16200000">
                <a:off x="1784792" y="2536027"/>
                <a:ext cx="379068" cy="1105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b">
                <a:noAutofit/>
              </a:bodyPr>
              <a:lstStyle>
                <a:lvl1pPr algn="l" defTabSz="914400">
                  <a:lnSpc>
                    <a:spcPct val="120000"/>
                  </a:lnSpc>
                  <a:spcBef>
                    <a:spcPts val="1200"/>
                  </a:spcBef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 dirty="0"/>
                  <a:t>FSC-H</a:t>
                </a:r>
              </a:p>
            </p:txBody>
          </p:sp>
          <p:cxnSp>
            <p:nvCxnSpPr>
              <p:cNvPr id="131" name="Straight Arrow Connector 130"/>
              <p:cNvCxnSpPr/>
              <p:nvPr/>
            </p:nvCxnSpPr>
            <p:spPr>
              <a:xfrm>
                <a:off x="2294350" y="2955060"/>
                <a:ext cx="929846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B97483FE-74C5-4D0C-BEBC-E5AC8480AB30}"/>
                </a:ext>
              </a:extLst>
            </p:cNvPr>
            <p:cNvGrpSpPr/>
            <p:nvPr/>
          </p:nvGrpSpPr>
          <p:grpSpPr>
            <a:xfrm>
              <a:off x="3116318" y="2193564"/>
              <a:ext cx="1322401" cy="1064249"/>
              <a:chOff x="3116318" y="2193564"/>
              <a:chExt cx="1322401" cy="1064249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3278775" y="2193564"/>
                <a:ext cx="915543" cy="915543"/>
              </a:xfrm>
              <a:prstGeom prst="rect">
                <a:avLst/>
              </a:prstGeom>
            </p:spPr>
          </p:pic>
          <p:sp>
            <p:nvSpPr>
              <p:cNvPr id="106" name="Shape 346"/>
              <p:cNvSpPr/>
              <p:nvPr/>
            </p:nvSpPr>
            <p:spPr>
              <a:xfrm>
                <a:off x="3504797" y="3147256"/>
                <a:ext cx="521114" cy="1105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>
                <a:lvl1pPr defTabSz="914400"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 dirty="0"/>
                  <a:t>Live/Dead</a:t>
                </a:r>
              </a:p>
            </p:txBody>
          </p:sp>
          <p:sp>
            <p:nvSpPr>
              <p:cNvPr id="119" name="Shape 351"/>
              <p:cNvSpPr/>
              <p:nvPr/>
            </p:nvSpPr>
            <p:spPr>
              <a:xfrm rot="16200000">
                <a:off x="2982063" y="2536027"/>
                <a:ext cx="379068" cy="1105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b">
                <a:noAutofit/>
              </a:bodyPr>
              <a:lstStyle>
                <a:lvl1pPr algn="l" defTabSz="914400">
                  <a:lnSpc>
                    <a:spcPct val="120000"/>
                  </a:lnSpc>
                  <a:spcBef>
                    <a:spcPts val="1200"/>
                  </a:spcBef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 dirty="0"/>
                  <a:t>SSC-A</a:t>
                </a:r>
              </a:p>
            </p:txBody>
          </p:sp>
          <p:cxnSp>
            <p:nvCxnSpPr>
              <p:cNvPr id="132" name="Straight Arrow Connector 131"/>
              <p:cNvCxnSpPr/>
              <p:nvPr/>
            </p:nvCxnSpPr>
            <p:spPr>
              <a:xfrm>
                <a:off x="3679068" y="2955060"/>
                <a:ext cx="75965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EE22E70C-3B7B-45E6-B958-E13861E74963}"/>
                </a:ext>
              </a:extLst>
            </p:cNvPr>
            <p:cNvGrpSpPr/>
            <p:nvPr/>
          </p:nvGrpSpPr>
          <p:grpSpPr>
            <a:xfrm>
              <a:off x="4354214" y="2193564"/>
              <a:ext cx="1051434" cy="1157457"/>
              <a:chOff x="4354214" y="2193564"/>
              <a:chExt cx="1051434" cy="1157457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4490105" y="2193564"/>
                <a:ext cx="915543" cy="915543"/>
              </a:xfrm>
              <a:prstGeom prst="rect">
                <a:avLst/>
              </a:prstGeom>
            </p:spPr>
          </p:pic>
          <p:sp>
            <p:nvSpPr>
              <p:cNvPr id="107" name="Shape 347"/>
              <p:cNvSpPr/>
              <p:nvPr/>
            </p:nvSpPr>
            <p:spPr>
              <a:xfrm>
                <a:off x="4844824" y="3147256"/>
                <a:ext cx="274728" cy="1105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b">
                <a:noAutofit/>
              </a:bodyPr>
              <a:lstStyle>
                <a:lvl1pPr defTabSz="914400"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/>
                  <a:t>CD3</a:t>
                </a:r>
              </a:p>
            </p:txBody>
          </p:sp>
          <p:sp>
            <p:nvSpPr>
              <p:cNvPr id="108" name="Shape 348"/>
              <p:cNvSpPr/>
              <p:nvPr/>
            </p:nvSpPr>
            <p:spPr>
              <a:xfrm rot="16200000">
                <a:off x="4219959" y="2536027"/>
                <a:ext cx="379068" cy="11055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0" tIns="0" rIns="0" bIns="0" numCol="1" anchor="b">
                <a:noAutofit/>
              </a:bodyPr>
              <a:lstStyle>
                <a:lvl1pPr algn="l" defTabSz="914400">
                  <a:lnSpc>
                    <a:spcPct val="120000"/>
                  </a:lnSpc>
                  <a:spcBef>
                    <a:spcPts val="1200"/>
                  </a:spcBef>
                  <a:defRPr sz="12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>
                  <a:defRPr sz="1800" b="1"/>
                </a:pPr>
                <a:r>
                  <a:rPr sz="844" dirty="0"/>
                  <a:t>CD56</a:t>
                </a:r>
              </a:p>
            </p:txBody>
          </p:sp>
          <p:cxnSp>
            <p:nvCxnSpPr>
              <p:cNvPr id="138" name="Straight Arrow Connector 137"/>
              <p:cNvCxnSpPr/>
              <p:nvPr/>
            </p:nvCxnSpPr>
            <p:spPr>
              <a:xfrm>
                <a:off x="4568562" y="2775468"/>
                <a:ext cx="0" cy="57555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non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D588AC27-1947-4714-87A0-B57BEE190E8F}"/>
                </a:ext>
              </a:extLst>
            </p:cNvPr>
            <p:cNvGrpSpPr/>
            <p:nvPr/>
          </p:nvGrpSpPr>
          <p:grpSpPr>
            <a:xfrm>
              <a:off x="1351260" y="3351021"/>
              <a:ext cx="3585038" cy="157037"/>
              <a:chOff x="1351260" y="3351021"/>
              <a:chExt cx="3585038" cy="157037"/>
            </a:xfrm>
          </p:grpSpPr>
          <p:cxnSp>
            <p:nvCxnSpPr>
              <p:cNvPr id="141" name="Straight Arrow Connector 140"/>
              <p:cNvCxnSpPr/>
              <p:nvPr/>
            </p:nvCxnSpPr>
            <p:spPr>
              <a:xfrm>
                <a:off x="3755198" y="3351021"/>
                <a:ext cx="0" cy="15703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Arrow Connector 142"/>
              <p:cNvCxnSpPr/>
              <p:nvPr/>
            </p:nvCxnSpPr>
            <p:spPr>
              <a:xfrm>
                <a:off x="2545191" y="3351021"/>
                <a:ext cx="0" cy="15703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Arrow Connector 143"/>
              <p:cNvCxnSpPr/>
              <p:nvPr/>
            </p:nvCxnSpPr>
            <p:spPr>
              <a:xfrm>
                <a:off x="1351260" y="3351021"/>
                <a:ext cx="0" cy="15703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Arrow Connector 144"/>
              <p:cNvCxnSpPr/>
              <p:nvPr/>
            </p:nvCxnSpPr>
            <p:spPr>
              <a:xfrm>
                <a:off x="1351260" y="3355040"/>
                <a:ext cx="3585038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non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Arrow Connector 146"/>
              <p:cNvCxnSpPr/>
              <p:nvPr/>
            </p:nvCxnSpPr>
            <p:spPr>
              <a:xfrm>
                <a:off x="4936298" y="3351021"/>
                <a:ext cx="0" cy="15703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sm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50" name="Straight Arrow Connector 149"/>
          <p:cNvCxnSpPr/>
          <p:nvPr/>
        </p:nvCxnSpPr>
        <p:spPr>
          <a:xfrm flipH="1">
            <a:off x="6092563" y="2677873"/>
            <a:ext cx="21315" cy="101075"/>
          </a:xfrm>
          <a:prstGeom prst="straightConnector1">
            <a:avLst/>
          </a:prstGeom>
          <a:ln w="12700">
            <a:solidFill>
              <a:schemeClr val="tx1"/>
            </a:solidFill>
            <a:tailEnd type="none" w="sm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FA2C5081-82AA-4054-8971-55F506389C44}"/>
              </a:ext>
            </a:extLst>
          </p:cNvPr>
          <p:cNvSpPr txBox="1"/>
          <p:nvPr/>
        </p:nvSpPr>
        <p:spPr>
          <a:xfrm>
            <a:off x="2225435" y="621792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F7A0E914-E629-4299-8EA0-8AAF0B61CE52}"/>
              </a:ext>
            </a:extLst>
          </p:cNvPr>
          <p:cNvSpPr txBox="1"/>
          <p:nvPr/>
        </p:nvSpPr>
        <p:spPr>
          <a:xfrm>
            <a:off x="1618702" y="4779956"/>
            <a:ext cx="9269835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: Gating strategy used to measure antibody-dependent NK cell activation (ADNKA)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) Gating strategy used to identify 6 populations of NK cells. NK cells were defined as live singlet lymphocytes that were CD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Brigh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r CD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From the CD5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K cell population we derived the KIR2DL1 (2DL1), KIR2DL/S2 (2DL2/S2), KIR2DL3 (2DL3), KIR3DL1 (3DL1) and NKG2A gates. We also examined the contribution of NKG2A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K cells from the CD5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Brigh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K cell population. This represents an “inclusive” gating strategy. For educational pairs analysis, we used an “exclusive” gating strategy to ascertain the contribution of NK populations expressing individual inhibitory NK receptor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NKR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to ADNKA. The exclusive strategy was done with a 5-way Boolean analysis on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NK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gates derived from the CD5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opulation and functional analysis was done only on single positiv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NK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xpressing populations (e.g. SP2DL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s 2DL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DL/S2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DL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DL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KG2A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(B) An example of functional responses characterized by CD107 expression, and IFN-γ and CCL4 secretion following stimulation by ADNKA or control stimulation in the absence of antibody. Functional responses were analyzed by gating on single positiv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NK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using Boolean gating to obtain the frequency of these cells positive for all possible combinations of the three functions tested (not depicted here). Background values for anti-HIV IgG (HIVIG) rgp120-coated CEM cell stimulation were derived from stimulation of PBMCs with rgp120-coated CEM cells in the absence of HIVI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5246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1</TotalTime>
  <Words>862</Words>
  <Application>Microsoft Office PowerPoint</Application>
  <PresentationFormat>Widescreen</PresentationFormat>
  <Paragraphs>100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3" baseType="lpstr">
      <vt:lpstr>Arial</vt:lpstr>
      <vt:lpstr>Ariel</vt:lpstr>
      <vt:lpstr>Calibri</vt:lpstr>
      <vt:lpstr>Calibri Light</vt:lpstr>
      <vt:lpstr>Helvetica</vt:lpstr>
      <vt:lpstr>Times New Roman</vt:lpstr>
      <vt:lpstr>Office Theme</vt:lpstr>
      <vt:lpstr>Prism 6</vt:lpstr>
      <vt:lpstr>GraphPad Prism 6 Project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Bernard, Dr.</dc:creator>
  <cp:lastModifiedBy>Nicole Bernard</cp:lastModifiedBy>
  <cp:revision>18</cp:revision>
  <dcterms:created xsi:type="dcterms:W3CDTF">2018-08-10T19:17:39Z</dcterms:created>
  <dcterms:modified xsi:type="dcterms:W3CDTF">2018-12-07T20:33:07Z</dcterms:modified>
</cp:coreProperties>
</file>